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handoutMasterIdLst>
    <p:handoutMasterId r:id="rId12"/>
  </p:handoutMasterIdLst>
  <p:sldIdLst>
    <p:sldId id="408" r:id="rId2"/>
    <p:sldId id="261" r:id="rId3"/>
    <p:sldId id="409" r:id="rId4"/>
    <p:sldId id="429" r:id="rId5"/>
    <p:sldId id="414" r:id="rId6"/>
    <p:sldId id="426" r:id="rId7"/>
    <p:sldId id="428" r:id="rId8"/>
    <p:sldId id="430" r:id="rId9"/>
    <p:sldId id="432" r:id="rId10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DC6D232-AEAA-42B0-BA88-F84648F3EDDF}" v="2" dt="2023-03-08T20:21:43.379"/>
    <p1510:client id="{5D3743EE-1F23-4FD1-8DF0-983FC66C8538}" v="2" dt="2023-03-08T00:16:26.39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43" autoAdjust="0"/>
    <p:restoredTop sz="80633" autoAdjust="0"/>
  </p:normalViewPr>
  <p:slideViewPr>
    <p:cSldViewPr snapToGrid="0">
      <p:cViewPr varScale="1">
        <p:scale>
          <a:sx n="92" d="100"/>
          <a:sy n="92" d="100"/>
        </p:scale>
        <p:origin x="120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1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handoutMaster" Target="handoutMasters/handoutMaster1.xml"/><Relationship Id="rId17" Type="http://schemas.microsoft.com/office/2016/11/relationships/changesInfo" Target="changesInfos/changesInfo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shra, Paras Kumar" userId="5afb679a-7b3b-4bf1-9530-83a5b452f1f9" providerId="ADAL" clId="{1DC6D232-AEAA-42B0-BA88-F84648F3EDDF}"/>
    <pc:docChg chg="custSel modSld">
      <pc:chgData name="Mishra, Paras Kumar" userId="5afb679a-7b3b-4bf1-9530-83a5b452f1f9" providerId="ADAL" clId="{1DC6D232-AEAA-42B0-BA88-F84648F3EDDF}" dt="2023-03-08T20:21:43.379" v="16"/>
      <pc:docMkLst>
        <pc:docMk/>
      </pc:docMkLst>
      <pc:sldChg chg="modNotesTx">
        <pc:chgData name="Mishra, Paras Kumar" userId="5afb679a-7b3b-4bf1-9530-83a5b452f1f9" providerId="ADAL" clId="{1DC6D232-AEAA-42B0-BA88-F84648F3EDDF}" dt="2023-03-08T01:03:07.973" v="5"/>
        <pc:sldMkLst>
          <pc:docMk/>
          <pc:sldMk cId="2813494004" sldId="261"/>
        </pc:sldMkLst>
      </pc:sldChg>
      <pc:sldChg chg="modNotesTx">
        <pc:chgData name="Mishra, Paras Kumar" userId="5afb679a-7b3b-4bf1-9530-83a5b452f1f9" providerId="ADAL" clId="{1DC6D232-AEAA-42B0-BA88-F84648F3EDDF}" dt="2023-03-08T01:03:31.614" v="6"/>
        <pc:sldMkLst>
          <pc:docMk/>
          <pc:sldMk cId="427679249" sldId="408"/>
        </pc:sldMkLst>
      </pc:sldChg>
      <pc:sldChg chg="modNotesTx">
        <pc:chgData name="Mishra, Paras Kumar" userId="5afb679a-7b3b-4bf1-9530-83a5b452f1f9" providerId="ADAL" clId="{1DC6D232-AEAA-42B0-BA88-F84648F3EDDF}" dt="2023-03-08T01:02:42.699" v="4"/>
        <pc:sldMkLst>
          <pc:docMk/>
          <pc:sldMk cId="4068332779" sldId="409"/>
        </pc:sldMkLst>
      </pc:sldChg>
      <pc:sldChg chg="modNotesTx">
        <pc:chgData name="Mishra, Paras Kumar" userId="5afb679a-7b3b-4bf1-9530-83a5b452f1f9" providerId="ADAL" clId="{1DC6D232-AEAA-42B0-BA88-F84648F3EDDF}" dt="2023-03-08T01:01:21.973" v="2"/>
        <pc:sldMkLst>
          <pc:docMk/>
          <pc:sldMk cId="3097521662" sldId="414"/>
        </pc:sldMkLst>
      </pc:sldChg>
      <pc:sldChg chg="modNotesTx">
        <pc:chgData name="Mishra, Paras Kumar" userId="5afb679a-7b3b-4bf1-9530-83a5b452f1f9" providerId="ADAL" clId="{1DC6D232-AEAA-42B0-BA88-F84648F3EDDF}" dt="2023-03-08T01:00:48.362" v="1"/>
        <pc:sldMkLst>
          <pc:docMk/>
          <pc:sldMk cId="3031011693" sldId="426"/>
        </pc:sldMkLst>
      </pc:sldChg>
      <pc:sldChg chg="modNotesTx">
        <pc:chgData name="Mishra, Paras Kumar" userId="5afb679a-7b3b-4bf1-9530-83a5b452f1f9" providerId="ADAL" clId="{1DC6D232-AEAA-42B0-BA88-F84648F3EDDF}" dt="2023-03-08T01:00:22.067" v="0"/>
        <pc:sldMkLst>
          <pc:docMk/>
          <pc:sldMk cId="1355272230" sldId="428"/>
        </pc:sldMkLst>
      </pc:sldChg>
      <pc:sldChg chg="delSp modSp mod modNotesTx">
        <pc:chgData name="Mishra, Paras Kumar" userId="5afb679a-7b3b-4bf1-9530-83a5b452f1f9" providerId="ADAL" clId="{1DC6D232-AEAA-42B0-BA88-F84648F3EDDF}" dt="2023-03-08T20:21:43.379" v="16"/>
        <pc:sldMkLst>
          <pc:docMk/>
          <pc:sldMk cId="3749264573" sldId="429"/>
        </pc:sldMkLst>
        <pc:spChg chg="mod">
          <ac:chgData name="Mishra, Paras Kumar" userId="5afb679a-7b3b-4bf1-9530-83a5b452f1f9" providerId="ADAL" clId="{1DC6D232-AEAA-42B0-BA88-F84648F3EDDF}" dt="2023-03-08T20:21:43.379" v="16"/>
          <ac:spMkLst>
            <pc:docMk/>
            <pc:sldMk cId="3749264573" sldId="429"/>
            <ac:spMk id="4" creationId="{5CD59701-5A69-476E-977A-AF56D88F4B3D}"/>
          </ac:spMkLst>
        </pc:spChg>
        <pc:spChg chg="mod">
          <ac:chgData name="Mishra, Paras Kumar" userId="5afb679a-7b3b-4bf1-9530-83a5b452f1f9" providerId="ADAL" clId="{1DC6D232-AEAA-42B0-BA88-F84648F3EDDF}" dt="2023-03-08T20:21:43.379" v="16"/>
          <ac:spMkLst>
            <pc:docMk/>
            <pc:sldMk cId="3749264573" sldId="429"/>
            <ac:spMk id="5" creationId="{88101082-90AA-4F83-8B02-676505CA1EC6}"/>
          </ac:spMkLst>
        </pc:spChg>
        <pc:spChg chg="mod">
          <ac:chgData name="Mishra, Paras Kumar" userId="5afb679a-7b3b-4bf1-9530-83a5b452f1f9" providerId="ADAL" clId="{1DC6D232-AEAA-42B0-BA88-F84648F3EDDF}" dt="2023-03-08T20:21:43.379" v="16"/>
          <ac:spMkLst>
            <pc:docMk/>
            <pc:sldMk cId="3749264573" sldId="429"/>
            <ac:spMk id="23" creationId="{6B0A62E0-DABC-406B-8877-0B2207D3C024}"/>
          </ac:spMkLst>
        </pc:spChg>
        <pc:spChg chg="mod">
          <ac:chgData name="Mishra, Paras Kumar" userId="5afb679a-7b3b-4bf1-9530-83a5b452f1f9" providerId="ADAL" clId="{1DC6D232-AEAA-42B0-BA88-F84648F3EDDF}" dt="2023-03-08T20:21:43.379" v="16"/>
          <ac:spMkLst>
            <pc:docMk/>
            <pc:sldMk cId="3749264573" sldId="429"/>
            <ac:spMk id="24" creationId="{B27A592E-F277-44E1-A567-61C0B2420F91}"/>
          </ac:spMkLst>
        </pc:spChg>
        <pc:spChg chg="del">
          <ac:chgData name="Mishra, Paras Kumar" userId="5afb679a-7b3b-4bf1-9530-83a5b452f1f9" providerId="ADAL" clId="{1DC6D232-AEAA-42B0-BA88-F84648F3EDDF}" dt="2023-03-08T20:20:59.930" v="7" actId="478"/>
          <ac:spMkLst>
            <pc:docMk/>
            <pc:sldMk cId="3749264573" sldId="429"/>
            <ac:spMk id="25" creationId="{DB6431CC-EEC0-4E9D-AF34-24E6CFE96EE7}"/>
          </ac:spMkLst>
        </pc:spChg>
        <pc:spChg chg="del">
          <ac:chgData name="Mishra, Paras Kumar" userId="5afb679a-7b3b-4bf1-9530-83a5b452f1f9" providerId="ADAL" clId="{1DC6D232-AEAA-42B0-BA88-F84648F3EDDF}" dt="2023-03-08T20:21:19.541" v="9" actId="478"/>
          <ac:spMkLst>
            <pc:docMk/>
            <pc:sldMk cId="3749264573" sldId="429"/>
            <ac:spMk id="26" creationId="{A0E3C9E2-5B9F-4568-B7EB-5E0CC5B80472}"/>
          </ac:spMkLst>
        </pc:spChg>
        <pc:spChg chg="mod">
          <ac:chgData name="Mishra, Paras Kumar" userId="5afb679a-7b3b-4bf1-9530-83a5b452f1f9" providerId="ADAL" clId="{1DC6D232-AEAA-42B0-BA88-F84648F3EDDF}" dt="2023-03-08T20:21:43.379" v="16"/>
          <ac:spMkLst>
            <pc:docMk/>
            <pc:sldMk cId="3749264573" sldId="429"/>
            <ac:spMk id="27" creationId="{614F0A23-3F7C-4082-BE75-776C405392EA}"/>
          </ac:spMkLst>
        </pc:spChg>
        <pc:spChg chg="mod">
          <ac:chgData name="Mishra, Paras Kumar" userId="5afb679a-7b3b-4bf1-9530-83a5b452f1f9" providerId="ADAL" clId="{1DC6D232-AEAA-42B0-BA88-F84648F3EDDF}" dt="2023-03-08T20:21:43.379" v="16"/>
          <ac:spMkLst>
            <pc:docMk/>
            <pc:sldMk cId="3749264573" sldId="429"/>
            <ac:spMk id="48" creationId="{EE6616EE-AC16-4F86-B340-39ADF88CA020}"/>
          </ac:spMkLst>
        </pc:spChg>
        <pc:grpChg chg="mod">
          <ac:chgData name="Mishra, Paras Kumar" userId="5afb679a-7b3b-4bf1-9530-83a5b452f1f9" providerId="ADAL" clId="{1DC6D232-AEAA-42B0-BA88-F84648F3EDDF}" dt="2023-03-08T20:21:43.379" v="16"/>
          <ac:grpSpMkLst>
            <pc:docMk/>
            <pc:sldMk cId="3749264573" sldId="429"/>
            <ac:grpSpMk id="6" creationId="{898BA35E-B770-499D-A07C-02BE14A43D44}"/>
          </ac:grpSpMkLst>
        </pc:grpChg>
        <pc:grpChg chg="mod">
          <ac:chgData name="Mishra, Paras Kumar" userId="5afb679a-7b3b-4bf1-9530-83a5b452f1f9" providerId="ADAL" clId="{1DC6D232-AEAA-42B0-BA88-F84648F3EDDF}" dt="2023-03-08T20:21:43.379" v="16"/>
          <ac:grpSpMkLst>
            <pc:docMk/>
            <pc:sldMk cId="3749264573" sldId="429"/>
            <ac:grpSpMk id="47" creationId="{50BF93C7-E1DA-4922-AF36-D1C2552E5921}"/>
          </ac:grpSpMkLst>
        </pc:grpChg>
        <pc:grpChg chg="mod">
          <ac:chgData name="Mishra, Paras Kumar" userId="5afb679a-7b3b-4bf1-9530-83a5b452f1f9" providerId="ADAL" clId="{1DC6D232-AEAA-42B0-BA88-F84648F3EDDF}" dt="2023-03-08T20:21:43.379" v="16"/>
          <ac:grpSpMkLst>
            <pc:docMk/>
            <pc:sldMk cId="3749264573" sldId="429"/>
            <ac:grpSpMk id="49" creationId="{E695F97A-9D06-4E59-AC53-4216682D27D1}"/>
          </ac:grpSpMkLst>
        </pc:grpChg>
        <pc:graphicFrameChg chg="mod">
          <ac:chgData name="Mishra, Paras Kumar" userId="5afb679a-7b3b-4bf1-9530-83a5b452f1f9" providerId="ADAL" clId="{1DC6D232-AEAA-42B0-BA88-F84648F3EDDF}" dt="2023-03-08T20:21:43.379" v="16"/>
          <ac:graphicFrameMkLst>
            <pc:docMk/>
            <pc:sldMk cId="3749264573" sldId="429"/>
            <ac:graphicFrameMk id="29" creationId="{610BF0C9-091C-4AE5-BA7D-19AB50A64EE9}"/>
          </ac:graphicFrameMkLst>
        </pc:graphicFrameChg>
        <pc:picChg chg="mod">
          <ac:chgData name="Mishra, Paras Kumar" userId="5afb679a-7b3b-4bf1-9530-83a5b452f1f9" providerId="ADAL" clId="{1DC6D232-AEAA-42B0-BA88-F84648F3EDDF}" dt="2023-03-08T20:21:43.379" v="16"/>
          <ac:picMkLst>
            <pc:docMk/>
            <pc:sldMk cId="3749264573" sldId="429"/>
            <ac:picMk id="20" creationId="{155244D4-BDF1-4DDE-96C2-823DC1008BBB}"/>
          </ac:picMkLst>
        </pc:picChg>
        <pc:picChg chg="mod">
          <ac:chgData name="Mishra, Paras Kumar" userId="5afb679a-7b3b-4bf1-9530-83a5b452f1f9" providerId="ADAL" clId="{1DC6D232-AEAA-42B0-BA88-F84648F3EDDF}" dt="2023-03-08T20:21:43.379" v="16"/>
          <ac:picMkLst>
            <pc:docMk/>
            <pc:sldMk cId="3749264573" sldId="429"/>
            <ac:picMk id="21" creationId="{A7371F6A-16D3-4F0A-8A6E-BA956BADC9DA}"/>
          </ac:picMkLst>
        </pc:picChg>
        <pc:picChg chg="mod">
          <ac:chgData name="Mishra, Paras Kumar" userId="5afb679a-7b3b-4bf1-9530-83a5b452f1f9" providerId="ADAL" clId="{1DC6D232-AEAA-42B0-BA88-F84648F3EDDF}" dt="2023-03-08T20:21:43.379" v="16"/>
          <ac:picMkLst>
            <pc:docMk/>
            <pc:sldMk cId="3749264573" sldId="429"/>
            <ac:picMk id="22" creationId="{F0036BEB-75E6-43BB-A394-D480BA33C2FE}"/>
          </ac:picMkLst>
        </pc:picChg>
      </pc:sldChg>
    </pc:docChg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94051DAE-ECB3-48AD-9CF5-A4FBA5FB51FF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412995AF-1DCE-4B25-9E38-D1DCB6B2CC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09382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E2910B95-8326-4BD0-A0B3-0B1C98D5BD47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221AFC7E-6BC1-4B2B-BFEB-0D4858044C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87390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Standardization of dose and time for MCMV infection in HL1 cells. A-B.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hase contrast imaging showing the morphology of HL1 cells after infection with different dose and time of MCMV. 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.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titer of MCMV after infecting HL1 cells with different MOI. 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.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ll viability measurement through ATP assay in uninfected (MOCK) and MCMV infected HL1 cells at three time points. Student’s t-test was performed. Values are mean ± SE. Each point represents one sample. n= 3-8. </a:t>
            </a:r>
            <a:r>
              <a:rPr lang="en-US" sz="1800">
                <a:effectLst/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*; </a:t>
            </a:r>
            <a:r>
              <a:rPr lang="en-US" sz="1800" i="1">
                <a:effectLst/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800">
                <a:effectLst/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&lt;0.05; ****;</a:t>
            </a:r>
            <a:r>
              <a:rPr lang="en-US" sz="1800" i="1">
                <a:effectLst/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 P</a:t>
            </a:r>
            <a:r>
              <a:rPr lang="en-US" sz="1800">
                <a:effectLst/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&lt;0.0001.</a:t>
            </a:r>
            <a:endParaRPr lang="en-US" sz="18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 defTabSz="931774">
              <a:defRPr/>
            </a:pP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1AFC7E-6BC1-4B2B-BFEB-0D4858044C28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4548778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. MCMV infection promotes cell survival and inhibits cell death which is independent of its necroptotic activity in HL1 cells. A. </a:t>
            </a:r>
            <a:r>
              <a:rPr lang="en-US" sz="1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hase contrast images of HL1 cells infected with MOCK, WT CMV and M45</a:t>
            </a:r>
            <a:r>
              <a:rPr lang="en-US" sz="18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ut </a:t>
            </a:r>
            <a:r>
              <a:rPr lang="en-US" sz="1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RHIM MCMV for 24 h. </a:t>
            </a:r>
            <a:r>
              <a:rPr lang="en-US" sz="18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asurement of cell viability by ATP assay. </a:t>
            </a:r>
            <a:r>
              <a:rPr lang="en-US" sz="18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sz="1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asurement of cytotoxicity by lactate dehydrogenase (LDH) assay using cell culture medium. One-way ANOVA followed by Tukey’s multiple comparison test was performed. Values are mean ± SE. Each point represents one sample. n= 6-8. </a:t>
            </a:r>
            <a:r>
              <a:rPr lang="en-US" sz="18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**; </a:t>
            </a:r>
            <a:r>
              <a:rPr lang="en-US" sz="1800" i="1" dirty="0">
                <a:effectLst/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8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&lt;0.01; ****;</a:t>
            </a:r>
            <a:r>
              <a:rPr lang="en-US" sz="1800" i="1" dirty="0">
                <a:effectLst/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 P</a:t>
            </a:r>
            <a:r>
              <a:rPr lang="en-US" sz="18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&lt;0.0001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endParaRPr lang="en-US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1AFC7E-6BC1-4B2B-BFEB-0D4858044C2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775947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kern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US" sz="18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Validating MCMV infection using uninfected (MOCK) and WT and M45</a:t>
            </a:r>
            <a:r>
              <a:rPr lang="en-US" sz="1800" b="1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ut</a:t>
            </a:r>
            <a:r>
              <a:rPr lang="en-US" sz="18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RHIM MCMV infected HL1 cells. A. </a:t>
            </a:r>
            <a:r>
              <a:rPr lang="en-US" sz="1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munoblotting and quantification of Immediate Early-1 (IE-1) viral protein showing successful infection of MCMV.  </a:t>
            </a:r>
            <a:r>
              <a:rPr lang="en-US" sz="18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munoblotting and quantification of Early-1 (E-1) viral protein. </a:t>
            </a:r>
            <a:r>
              <a:rPr lang="en-US" sz="18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sz="1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munoblotting and quantification of envelop glycoprotein (gB) showing replication of MCMV. One-way ANOVA followed by Tukey’s multiple comparison test was performed. Values are mean ± SE. Each point represents one sample. n= 6. </a:t>
            </a:r>
            <a:r>
              <a:rPr lang="en-US" sz="18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**; </a:t>
            </a:r>
            <a:r>
              <a:rPr lang="en-US" sz="1800" i="1" dirty="0">
                <a:effectLst/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8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&lt;0.01; ***; </a:t>
            </a:r>
            <a:r>
              <a:rPr lang="en-US" sz="1800" i="1" dirty="0">
                <a:effectLst/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8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&lt;0.001; ****;</a:t>
            </a:r>
            <a:r>
              <a:rPr lang="en-US" sz="1800" i="1" dirty="0">
                <a:effectLst/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 P</a:t>
            </a:r>
            <a:r>
              <a:rPr lang="en-US" sz="18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&lt;0.0001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b="1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21AFC7E-6BC1-4B2B-BFEB-0D4858044C28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38952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4. MCMV (both WT and M45</a:t>
            </a:r>
            <a:r>
              <a:rPr lang="en-US" sz="1800" b="1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ut</a:t>
            </a:r>
            <a:r>
              <a:rPr lang="en-US" sz="18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RHIM) infection decreases cytosolic and mitochondrial ROS in HL1 cells. A. </a:t>
            </a:r>
            <a:r>
              <a:rPr lang="en-US" sz="1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munofluorescence and quantification of cellular ROS in uninfected (MOCK), WT and M45</a:t>
            </a:r>
            <a:r>
              <a:rPr lang="en-US" sz="18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ut</a:t>
            </a:r>
            <a:r>
              <a:rPr lang="en-US" sz="1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RHIM MCMV infected HL1 cells. </a:t>
            </a:r>
            <a:r>
              <a:rPr lang="en-US" sz="18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en-US" sz="1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munofluorescence and quantification of mitochondrial ROS in uninfected (MOCK), WT and M45</a:t>
            </a:r>
            <a:r>
              <a:rPr lang="en-US" sz="1800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ut</a:t>
            </a:r>
            <a:r>
              <a:rPr lang="en-US" sz="1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RHIM MCMV infected HL1 cells. One-way ANOVA followed by Tukey’s multiple comparison test was performed. Values are mean ± SE. Each point represents one sample. n= 4-5. </a:t>
            </a:r>
            <a:r>
              <a:rPr lang="en-US" sz="18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*; </a:t>
            </a:r>
            <a:r>
              <a:rPr lang="en-US" sz="1800" i="1" dirty="0">
                <a:effectLst/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8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&lt;0.05; **; </a:t>
            </a:r>
            <a:r>
              <a:rPr lang="en-US" sz="1800" i="1" dirty="0">
                <a:effectLst/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8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&lt;0.01; ****;</a:t>
            </a:r>
            <a:r>
              <a:rPr lang="en-US" sz="1800" i="1" dirty="0">
                <a:effectLst/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 P</a:t>
            </a:r>
            <a:r>
              <a:rPr lang="en-US" sz="18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&lt;0.0001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21AFC7E-6BC1-4B2B-BFEB-0D4858044C28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285978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5. MCMV (both WT and M45</a:t>
            </a:r>
            <a:r>
              <a:rPr lang="en-US" sz="1800" b="1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ut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HIM) infection promotes mitochondrial biogenesis and mitochondrial mass in HL1 cells. A.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mmunoblotting and quantification of mitochondrial biogenesis marker - peroxisome proliferator-activated receptor coactivator 1-alpha (PGC1</a:t>
            </a:r>
            <a:r>
              <a:rPr lang="el-GR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α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- in the uninfected (MOCK) and MCMV infected HL1 cells. 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.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mmunoblotting and quantification of mitochondrial protein - transcription factor A, mitochondrial (TFAM) - in the uninfected (MOCK) and MCMV infected HL1 cells. One-way ANOVA followed by Tukey’s multiple comparison test was performed. Values are mean ± SE. Each point represents one sample. n= 5-6. </a:t>
            </a:r>
            <a:r>
              <a:rPr lang="en-US" sz="18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*; </a:t>
            </a:r>
            <a:r>
              <a:rPr lang="en-US" sz="1800" i="1" dirty="0">
                <a:effectLst/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8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&lt;0.05; **; </a:t>
            </a:r>
            <a:r>
              <a:rPr lang="en-US" sz="1800" i="1" dirty="0">
                <a:effectLst/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8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&lt;0.01; ***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1AFC7E-6BC1-4B2B-BFEB-0D4858044C28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487933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6. CMV infection induces TNF</a:t>
            </a:r>
            <a:r>
              <a:rPr lang="el-GR" sz="18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8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cardiac fibroblast. </a:t>
            </a:r>
            <a:r>
              <a:rPr lang="en-US" sz="1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hase-contrast imaging of uninfected and MCMV infected cardiac fibroblasts and quantification of tumor necrosis factor-alpha (TNF</a:t>
            </a:r>
            <a:r>
              <a:rPr lang="el-GR" sz="1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8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in the culture medium. Student’s t-test was performed. Values are mean ± SE. Each point represents one sample. n= 6-7. </a:t>
            </a:r>
            <a:r>
              <a:rPr lang="en-US" sz="18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**; </a:t>
            </a:r>
            <a:r>
              <a:rPr lang="en-US" sz="1800" i="1" dirty="0">
                <a:effectLst/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800" dirty="0">
                <a:effectLst/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&lt;0.01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21AFC7E-6BC1-4B2B-BFEB-0D4858044C28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635176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7. ZBP1 variant in cardiomyocytes. A.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mmunoblot and quantification of ZBP1 with molecular weight of 42 kDa in cardiomyocyte cell line HL1. One-way ANOVA followed by Tukey’s multiple comparison test was performed. Values are mean ± SE. Each point represents one sample. n= 6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21AFC7E-6BC1-4B2B-BFEB-0D4858044C28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4374620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8. Splice variants of mouse Zbp1. A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 snapshot from NCBI showing splice variants of mouse Zbp1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sz="1200" b="0" dirty="0">
                <a:latin typeface="Arial" panose="020B0604020202020204" pitchFamily="34" charset="0"/>
                <a:cs typeface="Arial" panose="020B0604020202020204" pitchFamily="34" charset="0"/>
              </a:rPr>
              <a:t>Presence and absence of RHIM domains in two splice variants of mouse Zbp1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b="0" dirty="0">
                <a:latin typeface="Arial" panose="020B0604020202020204" pitchFamily="34" charset="0"/>
                <a:cs typeface="Arial" panose="020B0604020202020204" pitchFamily="34" charset="0"/>
              </a:rPr>
              <a:t>RHIM motif sequences for Zbp1 was obtained from </a:t>
            </a:r>
            <a:r>
              <a:rPr lang="en-US" sz="1200" b="0" dirty="0" err="1">
                <a:latin typeface="Arial" panose="020B0604020202020204" pitchFamily="34" charset="0"/>
                <a:cs typeface="Arial" panose="020B0604020202020204" pitchFamily="34" charset="0"/>
              </a:rPr>
              <a:t>Uniprot</a:t>
            </a:r>
            <a:r>
              <a:rPr lang="en-US" sz="1200" b="0" dirty="0">
                <a:latin typeface="Arial" panose="020B0604020202020204" pitchFamily="34" charset="0"/>
                <a:cs typeface="Arial" panose="020B0604020202020204" pitchFamily="34" charset="0"/>
              </a:rPr>
              <a:t> database</a:t>
            </a:r>
            <a:r>
              <a:rPr lang="en-US" sz="1200" b="0" i="0" u="none" strike="noStrike" dirty="0">
                <a:solidFill>
                  <a:srgbClr val="161D39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Q9QY24, Q9QZL0, respectively. Serial Cloner software was used to localize the motifs sequence in the mRNA and protein sequences. Bio Render was used to create the graphical diagrams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21AFC7E-6BC1-4B2B-BFEB-0D4858044C28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9574233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9. ZBP1 interacting protein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b="0" dirty="0">
                <a:latin typeface="Arial" panose="020B0604020202020204" pitchFamily="34" charset="0"/>
                <a:cs typeface="Arial" panose="020B0604020202020204" pitchFamily="34" charset="0"/>
              </a:rPr>
              <a:t>List of proteins that are documented to interact with ZBP1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21AFC7E-6BC1-4B2B-BFEB-0D4858044C28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52029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D48FE-B794-4E03-9CB0-3EC39E80E161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1D5A64-3901-4C43-8486-41CEB8F958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78657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D48FE-B794-4E03-9CB0-3EC39E80E161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1D5A64-3901-4C43-8486-41CEB8F958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0573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D48FE-B794-4E03-9CB0-3EC39E80E161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1D5A64-3901-4C43-8486-41CEB8F958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43982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D48FE-B794-4E03-9CB0-3EC39E80E161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1D5A64-3901-4C43-8486-41CEB8F958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213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D48FE-B794-4E03-9CB0-3EC39E80E161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1D5A64-3901-4C43-8486-41CEB8F958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369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D48FE-B794-4E03-9CB0-3EC39E80E161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1D5A64-3901-4C43-8486-41CEB8F958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85002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D48FE-B794-4E03-9CB0-3EC39E80E161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1D5A64-3901-4C43-8486-41CEB8F958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71755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D48FE-B794-4E03-9CB0-3EC39E80E161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1D5A64-3901-4C43-8486-41CEB8F958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967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D48FE-B794-4E03-9CB0-3EC39E80E161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1D5A64-3901-4C43-8486-41CEB8F958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39281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D48FE-B794-4E03-9CB0-3EC39E80E161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1D5A64-3901-4C43-8486-41CEB8F958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5194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D48FE-B794-4E03-9CB0-3EC39E80E161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1D5A64-3901-4C43-8486-41CEB8F958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65999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5D48FE-B794-4E03-9CB0-3EC39E80E161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1D5A64-3901-4C43-8486-41CEB8F958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00467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6.png"/><Relationship Id="rId18" Type="http://schemas.microsoft.com/office/2007/relationships/hdphoto" Target="../media/hdphoto8.wdp"/><Relationship Id="rId26" Type="http://schemas.openxmlformats.org/officeDocument/2006/relationships/image" Target="../media/image12.emf"/><Relationship Id="rId3" Type="http://schemas.openxmlformats.org/officeDocument/2006/relationships/image" Target="../media/image1.png"/><Relationship Id="rId21" Type="http://schemas.openxmlformats.org/officeDocument/2006/relationships/image" Target="../media/image10.png"/><Relationship Id="rId7" Type="http://schemas.openxmlformats.org/officeDocument/2006/relationships/image" Target="../media/image3.png"/><Relationship Id="rId12" Type="http://schemas.microsoft.com/office/2007/relationships/hdphoto" Target="../media/hdphoto5.wdp"/><Relationship Id="rId17" Type="http://schemas.openxmlformats.org/officeDocument/2006/relationships/image" Target="../media/image8.png"/><Relationship Id="rId25" Type="http://schemas.openxmlformats.org/officeDocument/2006/relationships/oleObject" Target="../embeddings/oleObject2.bin"/><Relationship Id="rId2" Type="http://schemas.openxmlformats.org/officeDocument/2006/relationships/notesSlide" Target="../notesSlides/notesSlide1.xml"/><Relationship Id="rId16" Type="http://schemas.microsoft.com/office/2007/relationships/hdphoto" Target="../media/hdphoto7.wdp"/><Relationship Id="rId20" Type="http://schemas.microsoft.com/office/2007/relationships/hdphoto" Target="../media/hdphoto9.wdp"/><Relationship Id="rId29" Type="http://schemas.openxmlformats.org/officeDocument/2006/relationships/oleObject" Target="../embeddings/oleObject4.bin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24" Type="http://schemas.openxmlformats.org/officeDocument/2006/relationships/image" Target="../media/image11.emf"/><Relationship Id="rId5" Type="http://schemas.openxmlformats.org/officeDocument/2006/relationships/image" Target="../media/image2.png"/><Relationship Id="rId15" Type="http://schemas.openxmlformats.org/officeDocument/2006/relationships/image" Target="../media/image7.png"/><Relationship Id="rId23" Type="http://schemas.openxmlformats.org/officeDocument/2006/relationships/oleObject" Target="../embeddings/oleObject1.bin"/><Relationship Id="rId28" Type="http://schemas.openxmlformats.org/officeDocument/2006/relationships/image" Target="../media/image13.emf"/><Relationship Id="rId10" Type="http://schemas.microsoft.com/office/2007/relationships/hdphoto" Target="../media/hdphoto4.wdp"/><Relationship Id="rId19" Type="http://schemas.openxmlformats.org/officeDocument/2006/relationships/image" Target="../media/image9.png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microsoft.com/office/2007/relationships/hdphoto" Target="../media/hdphoto6.wdp"/><Relationship Id="rId22" Type="http://schemas.microsoft.com/office/2007/relationships/hdphoto" Target="../media/hdphoto10.wdp"/><Relationship Id="rId27" Type="http://schemas.openxmlformats.org/officeDocument/2006/relationships/oleObject" Target="../embeddings/oleObject3.bin"/><Relationship Id="rId30" Type="http://schemas.openxmlformats.org/officeDocument/2006/relationships/image" Target="../media/image14.emf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13.wdp"/><Relationship Id="rId3" Type="http://schemas.openxmlformats.org/officeDocument/2006/relationships/image" Target="../media/image15.png"/><Relationship Id="rId7" Type="http://schemas.openxmlformats.org/officeDocument/2006/relationships/image" Target="../media/image17.png"/><Relationship Id="rId12" Type="http://schemas.openxmlformats.org/officeDocument/2006/relationships/image" Target="../media/image19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microsoft.com/office/2007/relationships/hdphoto" Target="../media/hdphoto12.wdp"/><Relationship Id="rId11" Type="http://schemas.openxmlformats.org/officeDocument/2006/relationships/oleObject" Target="../embeddings/oleObject6.bin"/><Relationship Id="rId5" Type="http://schemas.openxmlformats.org/officeDocument/2006/relationships/image" Target="../media/image16.png"/><Relationship Id="rId10" Type="http://schemas.openxmlformats.org/officeDocument/2006/relationships/image" Target="../media/image18.emf"/><Relationship Id="rId4" Type="http://schemas.microsoft.com/office/2007/relationships/hdphoto" Target="../media/hdphoto11.wdp"/><Relationship Id="rId9" Type="http://schemas.openxmlformats.org/officeDocument/2006/relationships/oleObject" Target="../embeddings/oleObject5.bin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15.wdp"/><Relationship Id="rId13" Type="http://schemas.openxmlformats.org/officeDocument/2006/relationships/image" Target="../media/image25.png"/><Relationship Id="rId18" Type="http://schemas.microsoft.com/office/2007/relationships/hdphoto" Target="../media/hdphoto18.wdp"/><Relationship Id="rId3" Type="http://schemas.openxmlformats.org/officeDocument/2006/relationships/oleObject" Target="../embeddings/oleObject7.bin"/><Relationship Id="rId7" Type="http://schemas.openxmlformats.org/officeDocument/2006/relationships/image" Target="../media/image22.png"/><Relationship Id="rId12" Type="http://schemas.microsoft.com/office/2007/relationships/hdphoto" Target="../media/hdphoto16.wdp"/><Relationship Id="rId17" Type="http://schemas.openxmlformats.org/officeDocument/2006/relationships/image" Target="../media/image27.png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26.emf"/><Relationship Id="rId1" Type="http://schemas.openxmlformats.org/officeDocument/2006/relationships/slideLayout" Target="../slideLayouts/slideLayout7.xml"/><Relationship Id="rId6" Type="http://schemas.microsoft.com/office/2007/relationships/hdphoto" Target="../media/hdphoto14.wdp"/><Relationship Id="rId11" Type="http://schemas.openxmlformats.org/officeDocument/2006/relationships/image" Target="../media/image24.png"/><Relationship Id="rId5" Type="http://schemas.openxmlformats.org/officeDocument/2006/relationships/image" Target="../media/image21.png"/><Relationship Id="rId15" Type="http://schemas.openxmlformats.org/officeDocument/2006/relationships/oleObject" Target="../embeddings/oleObject9.bin"/><Relationship Id="rId10" Type="http://schemas.openxmlformats.org/officeDocument/2006/relationships/image" Target="../media/image23.emf"/><Relationship Id="rId19" Type="http://schemas.openxmlformats.org/officeDocument/2006/relationships/image" Target="../media/image28.png"/><Relationship Id="rId4" Type="http://schemas.openxmlformats.org/officeDocument/2006/relationships/image" Target="../media/image20.emf"/><Relationship Id="rId9" Type="http://schemas.openxmlformats.org/officeDocument/2006/relationships/oleObject" Target="../embeddings/oleObject8.bin"/><Relationship Id="rId14" Type="http://schemas.microsoft.com/office/2007/relationships/hdphoto" Target="../media/hdphoto17.wdp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21.wdp"/><Relationship Id="rId13" Type="http://schemas.openxmlformats.org/officeDocument/2006/relationships/image" Target="../media/image34.png"/><Relationship Id="rId18" Type="http://schemas.openxmlformats.org/officeDocument/2006/relationships/image" Target="../media/image36.emf"/><Relationship Id="rId3" Type="http://schemas.openxmlformats.org/officeDocument/2006/relationships/image" Target="../media/image29.png"/><Relationship Id="rId7" Type="http://schemas.openxmlformats.org/officeDocument/2006/relationships/image" Target="../media/image31.png"/><Relationship Id="rId12" Type="http://schemas.microsoft.com/office/2007/relationships/hdphoto" Target="../media/hdphoto22.wdp"/><Relationship Id="rId17" Type="http://schemas.openxmlformats.org/officeDocument/2006/relationships/oleObject" Target="../embeddings/oleObject11.bin"/><Relationship Id="rId2" Type="http://schemas.openxmlformats.org/officeDocument/2006/relationships/notesSlide" Target="../notesSlides/notesSlide4.xml"/><Relationship Id="rId16" Type="http://schemas.microsoft.com/office/2007/relationships/hdphoto" Target="../media/hdphoto24.wdp"/><Relationship Id="rId1" Type="http://schemas.openxmlformats.org/officeDocument/2006/relationships/slideLayout" Target="../slideLayouts/slideLayout7.xml"/><Relationship Id="rId6" Type="http://schemas.microsoft.com/office/2007/relationships/hdphoto" Target="../media/hdphoto20.wdp"/><Relationship Id="rId11" Type="http://schemas.openxmlformats.org/officeDocument/2006/relationships/image" Target="../media/image33.png"/><Relationship Id="rId5" Type="http://schemas.openxmlformats.org/officeDocument/2006/relationships/image" Target="../media/image30.png"/><Relationship Id="rId15" Type="http://schemas.openxmlformats.org/officeDocument/2006/relationships/image" Target="../media/image35.png"/><Relationship Id="rId10" Type="http://schemas.openxmlformats.org/officeDocument/2006/relationships/image" Target="../media/image32.emf"/><Relationship Id="rId4" Type="http://schemas.microsoft.com/office/2007/relationships/hdphoto" Target="../media/hdphoto19.wdp"/><Relationship Id="rId9" Type="http://schemas.openxmlformats.org/officeDocument/2006/relationships/oleObject" Target="../embeddings/oleObject10.bin"/><Relationship Id="rId14" Type="http://schemas.microsoft.com/office/2007/relationships/hdphoto" Target="../media/hdphoto23.wdp"/></Relationships>
</file>

<file path=ppt/slides/_rels/slide5.xml.rels><?xml version="1.0" encoding="UTF-8" standalone="yes"?>
<Relationships xmlns="http://schemas.openxmlformats.org/package/2006/relationships"><Relationship Id="rId8" Type="http://schemas.microsoft.com/office/2007/relationships/hdphoto" Target="../media/hdphoto27.wdp"/><Relationship Id="rId13" Type="http://schemas.openxmlformats.org/officeDocument/2006/relationships/image" Target="../media/image42.png"/><Relationship Id="rId18" Type="http://schemas.openxmlformats.org/officeDocument/2006/relationships/image" Target="../media/image45.png"/><Relationship Id="rId3" Type="http://schemas.openxmlformats.org/officeDocument/2006/relationships/image" Target="../media/image37.png"/><Relationship Id="rId7" Type="http://schemas.openxmlformats.org/officeDocument/2006/relationships/image" Target="../media/image39.png"/><Relationship Id="rId12" Type="http://schemas.microsoft.com/office/2007/relationships/hdphoto" Target="../media/hdphoto28.wdp"/><Relationship Id="rId17" Type="http://schemas.openxmlformats.org/officeDocument/2006/relationships/image" Target="../media/image44.png"/><Relationship Id="rId2" Type="http://schemas.openxmlformats.org/officeDocument/2006/relationships/notesSlide" Target="../notesSlides/notesSlide5.xml"/><Relationship Id="rId16" Type="http://schemas.openxmlformats.org/officeDocument/2006/relationships/image" Target="../media/image43.emf"/><Relationship Id="rId20" Type="http://schemas.openxmlformats.org/officeDocument/2006/relationships/image" Target="../media/image46.emf"/><Relationship Id="rId1" Type="http://schemas.openxmlformats.org/officeDocument/2006/relationships/slideLayout" Target="../slideLayouts/slideLayout2.xml"/><Relationship Id="rId6" Type="http://schemas.microsoft.com/office/2007/relationships/hdphoto" Target="../media/hdphoto26.wdp"/><Relationship Id="rId11" Type="http://schemas.openxmlformats.org/officeDocument/2006/relationships/image" Target="../media/image41.png"/><Relationship Id="rId5" Type="http://schemas.openxmlformats.org/officeDocument/2006/relationships/image" Target="../media/image38.png"/><Relationship Id="rId15" Type="http://schemas.openxmlformats.org/officeDocument/2006/relationships/oleObject" Target="../embeddings/oleObject13.bin"/><Relationship Id="rId10" Type="http://schemas.openxmlformats.org/officeDocument/2006/relationships/image" Target="../media/image40.emf"/><Relationship Id="rId19" Type="http://schemas.openxmlformats.org/officeDocument/2006/relationships/oleObject" Target="../embeddings/oleObject14.bin"/><Relationship Id="rId4" Type="http://schemas.microsoft.com/office/2007/relationships/hdphoto" Target="../media/hdphoto25.wdp"/><Relationship Id="rId9" Type="http://schemas.openxmlformats.org/officeDocument/2006/relationships/oleObject" Target="../embeddings/oleObject12.bin"/><Relationship Id="rId14" Type="http://schemas.microsoft.com/office/2007/relationships/hdphoto" Target="../media/hdphoto29.wdp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png"/><Relationship Id="rId7" Type="http://schemas.openxmlformats.org/officeDocument/2006/relationships/image" Target="../media/image49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15.bin"/><Relationship Id="rId5" Type="http://schemas.openxmlformats.org/officeDocument/2006/relationships/image" Target="../media/image48.tiff"/><Relationship Id="rId4" Type="http://schemas.microsoft.com/office/2007/relationships/hdphoto" Target="../media/hdphoto30.wdp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52.emf"/><Relationship Id="rId3" Type="http://schemas.openxmlformats.org/officeDocument/2006/relationships/image" Target="../media/image50.png"/><Relationship Id="rId7" Type="http://schemas.openxmlformats.org/officeDocument/2006/relationships/oleObject" Target="../embeddings/oleObject16.bin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9.wdp"/><Relationship Id="rId5" Type="http://schemas.openxmlformats.org/officeDocument/2006/relationships/image" Target="../media/image51.png"/><Relationship Id="rId4" Type="http://schemas.microsoft.com/office/2007/relationships/hdphoto" Target="../media/hdphoto31.wdp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4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F9CF5D6C-C8AE-4221-9B0E-1FAF0B134499}"/>
              </a:ext>
            </a:extLst>
          </p:cNvPr>
          <p:cNvGrpSpPr/>
          <p:nvPr/>
        </p:nvGrpSpPr>
        <p:grpSpPr>
          <a:xfrm>
            <a:off x="1554444" y="822970"/>
            <a:ext cx="3338601" cy="1910070"/>
            <a:chOff x="1102823" y="1619998"/>
            <a:chExt cx="3475354" cy="1839550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8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58153" y="2578157"/>
              <a:ext cx="1120024" cy="881233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9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90846" y="2578158"/>
              <a:ext cx="1134991" cy="881389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3458153" y="2578156"/>
              <a:ext cx="69609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OI=3 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256176" y="2578157"/>
              <a:ext cx="7113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OI=2</a:t>
              </a:r>
            </a:p>
          </p:txBody>
        </p:sp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04549" y="2578158"/>
              <a:ext cx="1169532" cy="881390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50000" contrast="6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02823" y="1619999"/>
              <a:ext cx="1171258" cy="918781"/>
            </a:xfrm>
            <a:prstGeom prst="rect">
              <a:avLst/>
            </a:prstGeom>
          </p:spPr>
        </p:pic>
        <p:sp>
          <p:nvSpPr>
            <p:cNvPr id="21" name="TextBox 20"/>
            <p:cNvSpPr txBox="1"/>
            <p:nvPr/>
          </p:nvSpPr>
          <p:spPr>
            <a:xfrm>
              <a:off x="1104549" y="2578158"/>
              <a:ext cx="724554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OI=1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102823" y="1619998"/>
              <a:ext cx="941856" cy="2667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OI=0.05</a:t>
              </a:r>
            </a:p>
          </p:txBody>
        </p:sp>
        <p:pic>
          <p:nvPicPr>
            <p:cNvPr id="27" name="Picture 26"/>
            <p:cNvPicPr>
              <a:picLocks noChangeAspect="1"/>
            </p:cNvPicPr>
            <p:nvPr/>
          </p:nvPicPr>
          <p:blipFill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45000" contrast="6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96837" y="1619999"/>
              <a:ext cx="1134991" cy="918781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9000" contrast="6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54585" y="1619998"/>
              <a:ext cx="1123592" cy="918781"/>
            </a:xfrm>
            <a:prstGeom prst="rect">
              <a:avLst/>
            </a:prstGeom>
          </p:spPr>
        </p:pic>
        <p:sp>
          <p:nvSpPr>
            <p:cNvPr id="30" name="TextBox 29"/>
            <p:cNvSpPr txBox="1"/>
            <p:nvPr/>
          </p:nvSpPr>
          <p:spPr>
            <a:xfrm>
              <a:off x="2290846" y="1619998"/>
              <a:ext cx="900183" cy="2667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OI=0.1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3431828" y="1619998"/>
              <a:ext cx="900183" cy="2760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OI=0.05</a:t>
              </a: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193431" y="334108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grpSp>
        <p:nvGrpSpPr>
          <p:cNvPr id="43" name="Group 42"/>
          <p:cNvGrpSpPr/>
          <p:nvPr/>
        </p:nvGrpSpPr>
        <p:grpSpPr>
          <a:xfrm>
            <a:off x="5374630" y="816955"/>
            <a:ext cx="2875621" cy="1915919"/>
            <a:chOff x="1227481" y="1367262"/>
            <a:chExt cx="3102786" cy="2255184"/>
          </a:xfrm>
        </p:grpSpPr>
        <p:pic>
          <p:nvPicPr>
            <p:cNvPr id="44" name="Picture 43"/>
            <p:cNvPicPr>
              <a:picLocks noChangeAspect="1"/>
            </p:cNvPicPr>
            <p:nvPr/>
          </p:nvPicPr>
          <p:blipFill>
            <a:blip r:embed="rId15" cstate="print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27482" y="1367262"/>
              <a:ext cx="1524562" cy="1105350"/>
            </a:xfrm>
            <a:prstGeom prst="rect">
              <a:avLst/>
            </a:prstGeom>
          </p:spPr>
        </p:pic>
        <p:pic>
          <p:nvPicPr>
            <p:cNvPr id="45" name="Picture 44"/>
            <p:cNvPicPr>
              <a:picLocks noChangeAspect="1"/>
            </p:cNvPicPr>
            <p:nvPr/>
          </p:nvPicPr>
          <p:blipFill>
            <a:blip r:embed="rId17" cstate="print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05706" y="1378761"/>
              <a:ext cx="1524561" cy="1093851"/>
            </a:xfrm>
            <a:prstGeom prst="rect">
              <a:avLst/>
            </a:prstGeom>
          </p:spPr>
        </p:pic>
        <p:sp>
          <p:nvSpPr>
            <p:cNvPr id="46" name="TextBox 45"/>
            <p:cNvSpPr txBox="1"/>
            <p:nvPr/>
          </p:nvSpPr>
          <p:spPr>
            <a:xfrm>
              <a:off x="1227481" y="1367262"/>
              <a:ext cx="979948" cy="5708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OI=0.05, 3</a:t>
              </a:r>
              <a:r>
                <a:rPr lang="en-US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rd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day</a:t>
              </a: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2805705" y="1378761"/>
              <a:ext cx="81594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OI=3</a:t>
              </a:r>
            </a:p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rd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day</a:t>
              </a:r>
            </a:p>
          </p:txBody>
        </p:sp>
        <p:pic>
          <p:nvPicPr>
            <p:cNvPr id="48" name="Picture 47"/>
            <p:cNvPicPr>
              <a:picLocks noChangeAspect="1"/>
            </p:cNvPicPr>
            <p:nvPr/>
          </p:nvPicPr>
          <p:blipFill>
            <a:blip r:embed="rId19" cstate="print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27481" y="2517096"/>
              <a:ext cx="1524562" cy="1105350"/>
            </a:xfrm>
            <a:prstGeom prst="rect">
              <a:avLst/>
            </a:prstGeom>
          </p:spPr>
        </p:pic>
        <p:sp>
          <p:nvSpPr>
            <p:cNvPr id="49" name="TextBox 48"/>
            <p:cNvSpPr txBox="1"/>
            <p:nvPr/>
          </p:nvSpPr>
          <p:spPr>
            <a:xfrm>
              <a:off x="1227481" y="2517096"/>
              <a:ext cx="999712" cy="5708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OI=0.05</a:t>
              </a:r>
            </a:p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en-US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th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day</a:t>
              </a:r>
            </a:p>
          </p:txBody>
        </p:sp>
        <p:pic>
          <p:nvPicPr>
            <p:cNvPr id="50" name="Picture 49"/>
            <p:cNvPicPr>
              <a:picLocks noChangeAspect="1"/>
            </p:cNvPicPr>
            <p:nvPr/>
          </p:nvPicPr>
          <p:blipFill>
            <a:blip r:embed="rId21" cstate="print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05705" y="2517096"/>
              <a:ext cx="1524562" cy="1105350"/>
            </a:xfrm>
            <a:prstGeom prst="rect">
              <a:avLst/>
            </a:prstGeom>
          </p:spPr>
        </p:pic>
        <p:sp>
          <p:nvSpPr>
            <p:cNvPr id="51" name="TextBox 50"/>
            <p:cNvSpPr txBox="1"/>
            <p:nvPr/>
          </p:nvSpPr>
          <p:spPr>
            <a:xfrm>
              <a:off x="2805705" y="2528595"/>
              <a:ext cx="744381" cy="5708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OI=3</a:t>
              </a:r>
            </a:p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en-US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th 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ay</a:t>
              </a:r>
            </a:p>
          </p:txBody>
        </p:sp>
      </p:grpSp>
      <p:sp>
        <p:nvSpPr>
          <p:cNvPr id="64" name="Rectangle 63"/>
          <p:cNvSpPr/>
          <p:nvPr/>
        </p:nvSpPr>
        <p:spPr>
          <a:xfrm>
            <a:off x="5164399" y="542877"/>
            <a:ext cx="28725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5" name="Rectangle 64"/>
          <p:cNvSpPr/>
          <p:nvPr/>
        </p:nvSpPr>
        <p:spPr>
          <a:xfrm>
            <a:off x="1221027" y="611107"/>
            <a:ext cx="28725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7" name="Rectangle 66"/>
          <p:cNvSpPr/>
          <p:nvPr/>
        </p:nvSpPr>
        <p:spPr>
          <a:xfrm>
            <a:off x="8330026" y="611107"/>
            <a:ext cx="2952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6AEC01AE-7E7A-4466-98DC-C3D82836E2E4}"/>
              </a:ext>
            </a:extLst>
          </p:cNvPr>
          <p:cNvGrpSpPr/>
          <p:nvPr/>
        </p:nvGrpSpPr>
        <p:grpSpPr>
          <a:xfrm>
            <a:off x="8570512" y="749606"/>
            <a:ext cx="2896001" cy="2407932"/>
            <a:chOff x="8754232" y="749607"/>
            <a:chExt cx="2896001" cy="2407932"/>
          </a:xfrm>
        </p:grpSpPr>
        <p:graphicFrame>
          <p:nvGraphicFramePr>
            <p:cNvPr id="88" name="Object 8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84478816"/>
                </p:ext>
              </p:extLst>
            </p:nvPr>
          </p:nvGraphicFramePr>
          <p:xfrm>
            <a:off x="8978470" y="949326"/>
            <a:ext cx="2671763" cy="22082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3" imgW="4258245" imgH="3165034" progId="Prism9.Document">
                    <p:embed/>
                  </p:oleObj>
                </mc:Choice>
                <mc:Fallback>
                  <p:oleObj name="Prism 9" r:id="rId23" imgW="4258245" imgH="3165034" progId="Prism9.Document">
                    <p:embed/>
                    <p:pic>
                      <p:nvPicPr>
                        <p:cNvPr id="88" name="Object 87"/>
                        <p:cNvPicPr/>
                        <p:nvPr/>
                      </p:nvPicPr>
                      <p:blipFill>
                        <a:blip r:embed="rId24"/>
                        <a:stretch>
                          <a:fillRect/>
                        </a:stretch>
                      </p:blipFill>
                      <p:spPr>
                        <a:xfrm>
                          <a:off x="8978470" y="949326"/>
                          <a:ext cx="2671763" cy="22082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9" name="TextBox 88"/>
            <p:cNvSpPr txBox="1"/>
            <p:nvPr/>
          </p:nvSpPr>
          <p:spPr>
            <a:xfrm rot="16200000">
              <a:off x="8158802" y="1684898"/>
              <a:ext cx="1398844" cy="2079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iter (log</a:t>
              </a:r>
              <a:r>
                <a:rPr lang="en-US" sz="12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0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fu/ml)</a:t>
              </a: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9336108" y="1018896"/>
              <a:ext cx="8058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 = 0.03</a:t>
              </a:r>
            </a:p>
          </p:txBody>
        </p:sp>
        <p:grpSp>
          <p:nvGrpSpPr>
            <p:cNvPr id="91" name="Group 90"/>
            <p:cNvGrpSpPr/>
            <p:nvPr/>
          </p:nvGrpSpPr>
          <p:grpSpPr>
            <a:xfrm>
              <a:off x="9427568" y="1316541"/>
              <a:ext cx="424096" cy="46650"/>
              <a:chOff x="4606567" y="4253896"/>
              <a:chExt cx="1129649" cy="286457"/>
            </a:xfrm>
          </p:grpSpPr>
          <p:cxnSp>
            <p:nvCxnSpPr>
              <p:cNvPr id="97" name="Straight Connector 96"/>
              <p:cNvCxnSpPr/>
              <p:nvPr/>
            </p:nvCxnSpPr>
            <p:spPr>
              <a:xfrm flipV="1">
                <a:off x="4606567" y="4255296"/>
                <a:ext cx="1129649" cy="4436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Straight Connector 97"/>
              <p:cNvCxnSpPr/>
              <p:nvPr/>
            </p:nvCxnSpPr>
            <p:spPr>
              <a:xfrm>
                <a:off x="5733591" y="4253896"/>
                <a:ext cx="0" cy="280621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Straight Connector 98"/>
              <p:cNvCxnSpPr/>
              <p:nvPr/>
            </p:nvCxnSpPr>
            <p:spPr>
              <a:xfrm>
                <a:off x="4606567" y="4259732"/>
                <a:ext cx="0" cy="280621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2" name="Group 91"/>
            <p:cNvGrpSpPr/>
            <p:nvPr/>
          </p:nvGrpSpPr>
          <p:grpSpPr>
            <a:xfrm>
              <a:off x="10394656" y="1076364"/>
              <a:ext cx="460117" cy="50794"/>
              <a:chOff x="4606567" y="4253896"/>
              <a:chExt cx="1129649" cy="286457"/>
            </a:xfrm>
          </p:grpSpPr>
          <p:cxnSp>
            <p:nvCxnSpPr>
              <p:cNvPr id="94" name="Straight Connector 93"/>
              <p:cNvCxnSpPr/>
              <p:nvPr/>
            </p:nvCxnSpPr>
            <p:spPr>
              <a:xfrm flipV="1">
                <a:off x="4606567" y="4255296"/>
                <a:ext cx="1129649" cy="4436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Straight Connector 94"/>
              <p:cNvCxnSpPr/>
              <p:nvPr/>
            </p:nvCxnSpPr>
            <p:spPr>
              <a:xfrm>
                <a:off x="5733591" y="4253896"/>
                <a:ext cx="0" cy="280621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" name="Straight Connector 95"/>
              <p:cNvCxnSpPr/>
              <p:nvPr/>
            </p:nvCxnSpPr>
            <p:spPr>
              <a:xfrm>
                <a:off x="4606567" y="4259732"/>
                <a:ext cx="0" cy="280621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3" name="TextBox 92"/>
            <p:cNvSpPr txBox="1"/>
            <p:nvPr/>
          </p:nvSpPr>
          <p:spPr>
            <a:xfrm>
              <a:off x="10268913" y="749607"/>
              <a:ext cx="7154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P 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= 0.1</a:t>
              </a:r>
            </a:p>
          </p:txBody>
        </p:sp>
      </p:grpSp>
      <p:graphicFrame>
        <p:nvGraphicFramePr>
          <p:cNvPr id="62" name="Object 61">
            <a:extLst>
              <a:ext uri="{FF2B5EF4-FFF2-40B4-BE49-F238E27FC236}">
                <a16:creationId xmlns:a16="http://schemas.microsoft.com/office/drawing/2014/main" id="{12F667E1-527A-43A1-9470-536B8E9E566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67008711"/>
              </p:ext>
            </p:extLst>
          </p:nvPr>
        </p:nvGraphicFramePr>
        <p:xfrm>
          <a:off x="1393825" y="3001963"/>
          <a:ext cx="2281238" cy="31956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5" imgW="2112916" imgH="3329984" progId="Prism9.Document">
                  <p:embed/>
                </p:oleObj>
              </mc:Choice>
              <mc:Fallback>
                <p:oleObj name="Prism 9" r:id="rId25" imgW="2112916" imgH="3329984" progId="Prism9.Document">
                  <p:embed/>
                  <p:pic>
                    <p:nvPicPr>
                      <p:cNvPr id="62" name="Object 61">
                        <a:extLst>
                          <a:ext uri="{FF2B5EF4-FFF2-40B4-BE49-F238E27FC236}">
                            <a16:creationId xmlns:a16="http://schemas.microsoft.com/office/drawing/2014/main" id="{12F667E1-527A-43A1-9470-536B8E9E566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1393825" y="3001963"/>
                        <a:ext cx="2281238" cy="31956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6" name="TextBox 65">
            <a:extLst>
              <a:ext uri="{FF2B5EF4-FFF2-40B4-BE49-F238E27FC236}">
                <a16:creationId xmlns:a16="http://schemas.microsoft.com/office/drawing/2014/main" id="{F04CCCA7-393E-40EF-A1E9-F897B98B96A9}"/>
              </a:ext>
            </a:extLst>
          </p:cNvPr>
          <p:cNvSpPr txBox="1"/>
          <p:nvPr/>
        </p:nvSpPr>
        <p:spPr>
          <a:xfrm>
            <a:off x="2672247" y="2906090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u="sng" dirty="0">
                <a:latin typeface="Arial" panose="020B0604020202020204" pitchFamily="34" charset="0"/>
                <a:cs typeface="Arial" panose="020B0604020202020204" pitchFamily="34" charset="0"/>
              </a:rPr>
              <a:t>24 h</a:t>
            </a:r>
          </a:p>
        </p:txBody>
      </p:sp>
      <p:graphicFrame>
        <p:nvGraphicFramePr>
          <p:cNvPr id="59" name="Object 58">
            <a:extLst>
              <a:ext uri="{FF2B5EF4-FFF2-40B4-BE49-F238E27FC236}">
                <a16:creationId xmlns:a16="http://schemas.microsoft.com/office/drawing/2014/main" id="{0FE8905F-BC7B-4EDF-8ECB-FB262F9F717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70075322"/>
              </p:ext>
            </p:extLst>
          </p:nvPr>
        </p:nvGraphicFramePr>
        <p:xfrm>
          <a:off x="3773909" y="3108784"/>
          <a:ext cx="2200768" cy="31272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7" imgW="2149650" imgH="3329984" progId="Prism9.Document">
                  <p:embed/>
                </p:oleObj>
              </mc:Choice>
              <mc:Fallback>
                <p:oleObj name="Prism 9" r:id="rId27" imgW="2149650" imgH="3329984" progId="Prism9.Document">
                  <p:embed/>
                  <p:pic>
                    <p:nvPicPr>
                      <p:cNvPr id="59" name="Object 58">
                        <a:extLst>
                          <a:ext uri="{FF2B5EF4-FFF2-40B4-BE49-F238E27FC236}">
                            <a16:creationId xmlns:a16="http://schemas.microsoft.com/office/drawing/2014/main" id="{0FE8905F-BC7B-4EDF-8ECB-FB262F9F717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3773909" y="3108784"/>
                        <a:ext cx="2200768" cy="31272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0" name="TextBox 59">
            <a:extLst>
              <a:ext uri="{FF2B5EF4-FFF2-40B4-BE49-F238E27FC236}">
                <a16:creationId xmlns:a16="http://schemas.microsoft.com/office/drawing/2014/main" id="{60619C1A-0DFF-4B43-8898-ABDF09EF3CB2}"/>
              </a:ext>
            </a:extLst>
          </p:cNvPr>
          <p:cNvSpPr txBox="1"/>
          <p:nvPr/>
        </p:nvSpPr>
        <p:spPr>
          <a:xfrm>
            <a:off x="4938296" y="2903240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u="sng" dirty="0">
                <a:latin typeface="Arial" panose="020B0604020202020204" pitchFamily="34" charset="0"/>
                <a:cs typeface="Arial" panose="020B0604020202020204" pitchFamily="34" charset="0"/>
              </a:rPr>
              <a:t>48 h</a:t>
            </a:r>
          </a:p>
        </p:txBody>
      </p:sp>
      <p:graphicFrame>
        <p:nvGraphicFramePr>
          <p:cNvPr id="56" name="Object 55">
            <a:extLst>
              <a:ext uri="{FF2B5EF4-FFF2-40B4-BE49-F238E27FC236}">
                <a16:creationId xmlns:a16="http://schemas.microsoft.com/office/drawing/2014/main" id="{6F72879D-BD03-4505-B662-E7E7DBFC686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14905761"/>
              </p:ext>
            </p:extLst>
          </p:nvPr>
        </p:nvGraphicFramePr>
        <p:xfrm>
          <a:off x="6076243" y="3247284"/>
          <a:ext cx="2400300" cy="29887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9" imgW="2177020" imgH="3329984" progId="Prism9.Document">
                  <p:embed/>
                </p:oleObj>
              </mc:Choice>
              <mc:Fallback>
                <p:oleObj name="Prism 9" r:id="rId29" imgW="2177020" imgH="3329984" progId="Prism9.Document">
                  <p:embed/>
                  <p:pic>
                    <p:nvPicPr>
                      <p:cNvPr id="56" name="Object 55">
                        <a:extLst>
                          <a:ext uri="{FF2B5EF4-FFF2-40B4-BE49-F238E27FC236}">
                            <a16:creationId xmlns:a16="http://schemas.microsoft.com/office/drawing/2014/main" id="{6F72879D-BD03-4505-B662-E7E7DBFC686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6076243" y="3247284"/>
                        <a:ext cx="2400300" cy="29887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7" name="TextBox 56">
            <a:extLst>
              <a:ext uri="{FF2B5EF4-FFF2-40B4-BE49-F238E27FC236}">
                <a16:creationId xmlns:a16="http://schemas.microsoft.com/office/drawing/2014/main" id="{2F4F1343-6987-45C4-BF78-D5B72B72416A}"/>
              </a:ext>
            </a:extLst>
          </p:cNvPr>
          <p:cNvSpPr txBox="1"/>
          <p:nvPr/>
        </p:nvSpPr>
        <p:spPr>
          <a:xfrm>
            <a:off x="7375458" y="2920551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u="sng" dirty="0">
                <a:latin typeface="Arial" panose="020B0604020202020204" pitchFamily="34" charset="0"/>
                <a:cs typeface="Arial" panose="020B0604020202020204" pitchFamily="34" charset="0"/>
              </a:rPr>
              <a:t>72 h</a:t>
            </a:r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FD5E7D8B-7C44-4EB2-84E0-C534DC0B5866}"/>
              </a:ext>
            </a:extLst>
          </p:cNvPr>
          <p:cNvSpPr/>
          <p:nvPr/>
        </p:nvSpPr>
        <p:spPr>
          <a:xfrm>
            <a:off x="1189025" y="3059051"/>
            <a:ext cx="2952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4276792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TextBox 54"/>
          <p:cNvSpPr txBox="1"/>
          <p:nvPr/>
        </p:nvSpPr>
        <p:spPr>
          <a:xfrm>
            <a:off x="87777" y="153727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grpSp>
        <p:nvGrpSpPr>
          <p:cNvPr id="13" name="Group 12"/>
          <p:cNvGrpSpPr/>
          <p:nvPr/>
        </p:nvGrpSpPr>
        <p:grpSpPr>
          <a:xfrm>
            <a:off x="1261816" y="996136"/>
            <a:ext cx="5000106" cy="1227989"/>
            <a:chOff x="1147006" y="2021684"/>
            <a:chExt cx="3707319" cy="1007396"/>
          </a:xfrm>
        </p:grpSpPr>
        <p:pic>
          <p:nvPicPr>
            <p:cNvPr id="42" name="Picture 41"/>
            <p:cNvPicPr>
              <a:picLocks noChangeAspect="1"/>
            </p:cNvPicPr>
            <p:nvPr/>
          </p:nvPicPr>
          <p:blipFill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36000" contrast="3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19540" y="2021685"/>
              <a:ext cx="1216075" cy="1007395"/>
            </a:xfrm>
            <a:prstGeom prst="rect">
              <a:avLst/>
            </a:prstGeom>
          </p:spPr>
        </p:pic>
        <p:pic>
          <p:nvPicPr>
            <p:cNvPr id="43" name="Picture 42"/>
            <p:cNvPicPr>
              <a:picLocks noChangeAspect="1"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0000" contrast="4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70322" y="2021685"/>
              <a:ext cx="1225902" cy="1007395"/>
            </a:xfrm>
            <a:prstGeom prst="rect">
              <a:avLst/>
            </a:prstGeom>
          </p:spPr>
        </p:pic>
        <p:pic>
          <p:nvPicPr>
            <p:cNvPr id="44" name="Picture 43"/>
            <p:cNvPicPr>
              <a:picLocks noChangeAspect="1"/>
            </p:cNvPicPr>
            <p:nvPr/>
          </p:nvPicPr>
          <p:blipFill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40000" contrast="2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58930" y="2021684"/>
              <a:ext cx="1195395" cy="1004761"/>
            </a:xfrm>
            <a:prstGeom prst="rect">
              <a:avLst/>
            </a:prstGeom>
          </p:spPr>
        </p:pic>
        <p:sp>
          <p:nvSpPr>
            <p:cNvPr id="45" name="TextBox 44"/>
            <p:cNvSpPr txBox="1"/>
            <p:nvPr/>
          </p:nvSpPr>
          <p:spPr>
            <a:xfrm>
              <a:off x="1147006" y="2023462"/>
              <a:ext cx="644556" cy="2055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2456928" y="2023461"/>
              <a:ext cx="763528" cy="2272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WT MCMV</a:t>
              </a: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3635615" y="2025340"/>
              <a:ext cx="996901" cy="3787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45</a:t>
              </a:r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mut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RHIM MCMV</a:t>
              </a:r>
            </a:p>
          </p:txBody>
        </p:sp>
      </p:grpSp>
      <p:sp>
        <p:nvSpPr>
          <p:cNvPr id="54" name="Rectangle 53"/>
          <p:cNvSpPr/>
          <p:nvPr/>
        </p:nvSpPr>
        <p:spPr>
          <a:xfrm>
            <a:off x="3964665" y="2343389"/>
            <a:ext cx="2952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7" name="Rectangle 56"/>
          <p:cNvSpPr/>
          <p:nvPr/>
        </p:nvSpPr>
        <p:spPr>
          <a:xfrm>
            <a:off x="974558" y="719137"/>
            <a:ext cx="28725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6" name="Rectangle 55"/>
          <p:cNvSpPr/>
          <p:nvPr/>
        </p:nvSpPr>
        <p:spPr>
          <a:xfrm>
            <a:off x="1006464" y="2293945"/>
            <a:ext cx="28725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1DB24ADC-1D69-4AEB-9FFE-2E772B21DD2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95954304"/>
              </p:ext>
            </p:extLst>
          </p:nvPr>
        </p:nvGraphicFramePr>
        <p:xfrm>
          <a:off x="1307881" y="2245453"/>
          <a:ext cx="2247630" cy="37430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9" imgW="2512667" imgH="4185350" progId="Prism9.Document">
                  <p:embed/>
                </p:oleObj>
              </mc:Choice>
              <mc:Fallback>
                <p:oleObj name="Prism 9" r:id="rId9" imgW="2512667" imgH="4185350" progId="Prism9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1DB24ADC-1D69-4AEB-9FFE-2E772B21DD2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307881" y="2245453"/>
                        <a:ext cx="2247630" cy="37430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B821E553-B767-4171-AACD-BC340D0DC6B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25260039"/>
              </p:ext>
            </p:extLst>
          </p:nvPr>
        </p:nvGraphicFramePr>
        <p:xfrm>
          <a:off x="4274098" y="2305976"/>
          <a:ext cx="2125029" cy="36824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1" imgW="2553722" imgH="4427734" progId="Prism9.Document">
                  <p:embed/>
                </p:oleObj>
              </mc:Choice>
              <mc:Fallback>
                <p:oleObj name="Prism 9" r:id="rId11" imgW="2553722" imgH="4427734" progId="Prism9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B821E553-B767-4171-AACD-BC340D0DC6B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274098" y="2305976"/>
                        <a:ext cx="2125029" cy="36824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8134940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5B922E4E-F04D-4264-8CF6-61ECD8290D18}"/>
              </a:ext>
            </a:extLst>
          </p:cNvPr>
          <p:cNvGrpSpPr/>
          <p:nvPr/>
        </p:nvGrpSpPr>
        <p:grpSpPr>
          <a:xfrm>
            <a:off x="4331339" y="1291992"/>
            <a:ext cx="3755928" cy="4459196"/>
            <a:chOff x="4331339" y="1291992"/>
            <a:chExt cx="3755928" cy="4459196"/>
          </a:xfrm>
        </p:grpSpPr>
        <p:graphicFrame>
          <p:nvGraphicFramePr>
            <p:cNvPr id="10" name="Object 9">
              <a:extLst>
                <a:ext uri="{FF2B5EF4-FFF2-40B4-BE49-F238E27FC236}">
                  <a16:creationId xmlns:a16="http://schemas.microsoft.com/office/drawing/2014/main" id="{9B1B70FD-ECDD-42A7-A7AD-4B0EC58FDF8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80664363"/>
                </p:ext>
              </p:extLst>
            </p:nvPr>
          </p:nvGraphicFramePr>
          <p:xfrm>
            <a:off x="5010076" y="1990400"/>
            <a:ext cx="2252662" cy="37607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3" imgW="2253369" imgH="3761449" progId="Prism9.Document">
                    <p:embed/>
                  </p:oleObj>
                </mc:Choice>
                <mc:Fallback>
                  <p:oleObj name="Prism 9" r:id="rId3" imgW="2253369" imgH="3761449" progId="Prism9.Document">
                    <p:embed/>
                    <p:pic>
                      <p:nvPicPr>
                        <p:cNvPr id="10" name="Object 9">
                          <a:extLst>
                            <a:ext uri="{FF2B5EF4-FFF2-40B4-BE49-F238E27FC236}">
                              <a16:creationId xmlns:a16="http://schemas.microsoft.com/office/drawing/2014/main" id="{9B1B70FD-ECDD-42A7-A7AD-4B0EC58FDF8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5010076" y="1990400"/>
                          <a:ext cx="2252662" cy="37607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51" name="Group 50">
              <a:extLst>
                <a:ext uri="{FF2B5EF4-FFF2-40B4-BE49-F238E27FC236}">
                  <a16:creationId xmlns:a16="http://schemas.microsoft.com/office/drawing/2014/main" id="{5EE92F62-3B7F-472C-A561-79345F635FE8}"/>
                </a:ext>
              </a:extLst>
            </p:cNvPr>
            <p:cNvGrpSpPr/>
            <p:nvPr/>
          </p:nvGrpSpPr>
          <p:grpSpPr>
            <a:xfrm>
              <a:off x="4331339" y="1291992"/>
              <a:ext cx="3755928" cy="739547"/>
              <a:chOff x="380699" y="379210"/>
              <a:chExt cx="3755928" cy="739547"/>
            </a:xfrm>
          </p:grpSpPr>
          <p:grpSp>
            <p:nvGrpSpPr>
              <p:cNvPr id="3" name="Group 2">
                <a:extLst>
                  <a:ext uri="{FF2B5EF4-FFF2-40B4-BE49-F238E27FC236}">
                    <a16:creationId xmlns:a16="http://schemas.microsoft.com/office/drawing/2014/main" id="{602888CE-747C-4346-A422-B9C65FF49F3B}"/>
                  </a:ext>
                </a:extLst>
              </p:cNvPr>
              <p:cNvGrpSpPr/>
              <p:nvPr/>
            </p:nvGrpSpPr>
            <p:grpSpPr>
              <a:xfrm>
                <a:off x="1167230" y="419486"/>
                <a:ext cx="1721269" cy="659130"/>
                <a:chOff x="7372555" y="4732231"/>
                <a:chExt cx="1355588" cy="527583"/>
              </a:xfrm>
            </p:grpSpPr>
            <p:pic>
              <p:nvPicPr>
                <p:cNvPr id="7" name="Picture 6">
                  <a:extLst>
                    <a:ext uri="{FF2B5EF4-FFF2-40B4-BE49-F238E27FC236}">
                      <a16:creationId xmlns:a16="http://schemas.microsoft.com/office/drawing/2014/main" id="{66E3336E-B747-4E71-8246-D46EA5BE44C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BEBA8EAE-BF5A-486C-A8C5-ECC9F3942E4B}">
                      <a14:imgProps xmlns:a14="http://schemas.microsoft.com/office/drawing/2010/main">
                        <a14:imgLayer r:embed="rId6">
                          <a14:imgEffect>
                            <a14:brightnessContrast bright="-20000" contrast="40000"/>
                          </a14:imgEffect>
                        </a14:imgLayer>
                      </a14:imgProps>
                    </a:ext>
                  </a:extLst>
                </a:blip>
                <a:srcRect l="26832" t="53020" r="54296" b="38937"/>
                <a:stretch/>
              </p:blipFill>
              <p:spPr>
                <a:xfrm>
                  <a:off x="7385390" y="4732231"/>
                  <a:ext cx="1342753" cy="275190"/>
                </a:xfrm>
                <a:prstGeom prst="rect">
                  <a:avLst/>
                </a:prstGeom>
              </p:spPr>
            </p:pic>
            <p:pic>
              <p:nvPicPr>
                <p:cNvPr id="8" name="Picture 7">
                  <a:extLst>
                    <a:ext uri="{FF2B5EF4-FFF2-40B4-BE49-F238E27FC236}">
                      <a16:creationId xmlns:a16="http://schemas.microsoft.com/office/drawing/2014/main" id="{07A48CD8-73A3-4CDF-922A-344336A4727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>
                  <a:extLst>
                    <a:ext uri="{BEBA8EAE-BF5A-486C-A8C5-ECC9F3942E4B}">
                      <a14:imgProps xmlns:a14="http://schemas.microsoft.com/office/drawing/2010/main">
                        <a14:imgLayer r:embed="rId8">
                          <a14:imgEffect>
                            <a14:brightnessContrast bright="-20000" contrast="20000"/>
                          </a14:imgEffect>
                        </a14:imgLayer>
                      </a14:imgProps>
                    </a:ext>
                  </a:extLst>
                </a:blip>
                <a:srcRect l="28071" t="52411" r="54102" b="41340"/>
                <a:stretch/>
              </p:blipFill>
              <p:spPr>
                <a:xfrm>
                  <a:off x="7372555" y="5040966"/>
                  <a:ext cx="1342753" cy="218848"/>
                </a:xfrm>
                <a:prstGeom prst="rect">
                  <a:avLst/>
                </a:prstGeom>
              </p:spPr>
            </p:pic>
          </p:grp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018E3D97-EF48-496A-BD4B-81945955A017}"/>
                  </a:ext>
                </a:extLst>
              </p:cNvPr>
              <p:cNvSpPr txBox="1"/>
              <p:nvPr/>
            </p:nvSpPr>
            <p:spPr>
              <a:xfrm>
                <a:off x="800045" y="419483"/>
                <a:ext cx="41389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E1</a:t>
                </a: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94B7CD78-D6ED-4CB0-90CA-D77BB41849B5}"/>
                  </a:ext>
                </a:extLst>
              </p:cNvPr>
              <p:cNvSpPr txBox="1"/>
              <p:nvPr/>
            </p:nvSpPr>
            <p:spPr>
              <a:xfrm>
                <a:off x="2861919" y="379210"/>
                <a:ext cx="127470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(40-43 </a:t>
                </a:r>
                <a:r>
                  <a:rPr lang="en-US" dirty="0" err="1"/>
                  <a:t>kDa</a:t>
                </a:r>
                <a:r>
                  <a:rPr lang="en-US" dirty="0"/>
                  <a:t>)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00CD81A6-4AD1-4079-87BA-ED8075070B48}"/>
                  </a:ext>
                </a:extLst>
              </p:cNvPr>
              <p:cNvSpPr txBox="1"/>
              <p:nvPr/>
            </p:nvSpPr>
            <p:spPr>
              <a:xfrm>
                <a:off x="2940164" y="749425"/>
                <a:ext cx="82907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43 </a:t>
                </a:r>
                <a:r>
                  <a:rPr lang="en-US" dirty="0" err="1"/>
                  <a:t>kDa</a:t>
                </a:r>
                <a:endParaRPr lang="en-US" dirty="0"/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5F6A5879-494E-4A8C-8739-9745B0E6EC73}"/>
                  </a:ext>
                </a:extLst>
              </p:cNvPr>
              <p:cNvSpPr txBox="1"/>
              <p:nvPr/>
            </p:nvSpPr>
            <p:spPr>
              <a:xfrm>
                <a:off x="380699" y="749425"/>
                <a:ext cx="83869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dirty="0"/>
                  <a:t>β</a:t>
                </a:r>
                <a:r>
                  <a:rPr lang="en-US" dirty="0"/>
                  <a:t>-actin</a:t>
                </a:r>
              </a:p>
            </p:txBody>
          </p:sp>
        </p:grp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0117EAC2-942B-4AF0-B9B5-18683B18A4DC}"/>
              </a:ext>
            </a:extLst>
          </p:cNvPr>
          <p:cNvGrpSpPr/>
          <p:nvPr/>
        </p:nvGrpSpPr>
        <p:grpSpPr>
          <a:xfrm>
            <a:off x="456942" y="1259305"/>
            <a:ext cx="3755928" cy="4282045"/>
            <a:chOff x="456942" y="1259305"/>
            <a:chExt cx="3755928" cy="4282045"/>
          </a:xfrm>
        </p:grpSpPr>
        <p:graphicFrame>
          <p:nvGraphicFramePr>
            <p:cNvPr id="22" name="Object 21">
              <a:extLst>
                <a:ext uri="{FF2B5EF4-FFF2-40B4-BE49-F238E27FC236}">
                  <a16:creationId xmlns:a16="http://schemas.microsoft.com/office/drawing/2014/main" id="{FDBB6734-AC20-4974-9EDE-D5945828F60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05483966"/>
                </p:ext>
              </p:extLst>
            </p:nvPr>
          </p:nvGraphicFramePr>
          <p:xfrm>
            <a:off x="991633" y="2209187"/>
            <a:ext cx="2149475" cy="33321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9" imgW="2253369" imgH="3494575" progId="Prism9.Document">
                    <p:embed/>
                  </p:oleObj>
                </mc:Choice>
                <mc:Fallback>
                  <p:oleObj name="Prism 9" r:id="rId9" imgW="2253369" imgH="3494575" progId="Prism9.Document">
                    <p:embed/>
                    <p:pic>
                      <p:nvPicPr>
                        <p:cNvPr id="22" name="Object 21">
                          <a:extLst>
                            <a:ext uri="{FF2B5EF4-FFF2-40B4-BE49-F238E27FC236}">
                              <a16:creationId xmlns:a16="http://schemas.microsoft.com/office/drawing/2014/main" id="{FDBB6734-AC20-4974-9EDE-D5945828F60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991633" y="2209187"/>
                          <a:ext cx="2149475" cy="33321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D73E1FF2-D8FC-49A2-9A7B-1BF49FCFD98D}"/>
                </a:ext>
              </a:extLst>
            </p:cNvPr>
            <p:cNvGrpSpPr/>
            <p:nvPr/>
          </p:nvGrpSpPr>
          <p:grpSpPr>
            <a:xfrm>
              <a:off x="456942" y="1259305"/>
              <a:ext cx="3755928" cy="739547"/>
              <a:chOff x="456942" y="1259305"/>
              <a:chExt cx="3755928" cy="739547"/>
            </a:xfrm>
          </p:grpSpPr>
          <p:grpSp>
            <p:nvGrpSpPr>
              <p:cNvPr id="18" name="Group 17">
                <a:extLst>
                  <a:ext uri="{FF2B5EF4-FFF2-40B4-BE49-F238E27FC236}">
                    <a16:creationId xmlns:a16="http://schemas.microsoft.com/office/drawing/2014/main" id="{B123D81C-CFBE-4307-B373-09ADD3D615A7}"/>
                  </a:ext>
                </a:extLst>
              </p:cNvPr>
              <p:cNvGrpSpPr/>
              <p:nvPr/>
            </p:nvGrpSpPr>
            <p:grpSpPr>
              <a:xfrm>
                <a:off x="1299946" y="1316650"/>
                <a:ext cx="1704969" cy="673750"/>
                <a:chOff x="5656746" y="4878991"/>
                <a:chExt cx="1313880" cy="511288"/>
              </a:xfrm>
            </p:grpSpPr>
            <p:pic>
              <p:nvPicPr>
                <p:cNvPr id="19" name="Picture 18">
                  <a:extLst>
                    <a:ext uri="{FF2B5EF4-FFF2-40B4-BE49-F238E27FC236}">
                      <a16:creationId xmlns:a16="http://schemas.microsoft.com/office/drawing/2014/main" id="{15053DC7-7B00-46D8-9E62-0188FB244B4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>
                  <a:extLst>
                    <a:ext uri="{BEBA8EAE-BF5A-486C-A8C5-ECC9F3942E4B}">
                      <a14:imgProps xmlns:a14="http://schemas.microsoft.com/office/drawing/2010/main">
                        <a14:imgLayer r:embed="rId12">
                          <a14:imgEffect>
                            <a14:brightnessContrast bright="-20000" contrast="40000"/>
                          </a14:imgEffect>
                        </a14:imgLayer>
                      </a14:imgProps>
                    </a:ext>
                  </a:extLst>
                </a:blip>
                <a:srcRect l="22526" t="39158" r="58758" b="52846"/>
                <a:stretch/>
              </p:blipFill>
              <p:spPr>
                <a:xfrm>
                  <a:off x="5656746" y="4878991"/>
                  <a:ext cx="1313880" cy="260903"/>
                </a:xfrm>
                <a:prstGeom prst="rect">
                  <a:avLst/>
                </a:prstGeom>
              </p:spPr>
            </p:pic>
            <p:pic>
              <p:nvPicPr>
                <p:cNvPr id="20" name="Picture 19">
                  <a:extLst>
                    <a:ext uri="{FF2B5EF4-FFF2-40B4-BE49-F238E27FC236}">
                      <a16:creationId xmlns:a16="http://schemas.microsoft.com/office/drawing/2014/main" id="{FCBC0EF9-479B-4E66-A60A-5A6CE3318A7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3">
                  <a:extLst>
                    <a:ext uri="{BEBA8EAE-BF5A-486C-A8C5-ECC9F3942E4B}">
                      <a14:imgProps xmlns:a14="http://schemas.microsoft.com/office/drawing/2010/main">
                        <a14:imgLayer r:embed="rId14">
                          <a14:imgEffect>
                            <a14:brightnessContrast bright="-20000" contrast="40000"/>
                          </a14:imgEffect>
                        </a14:imgLayer>
                      </a14:imgProps>
                    </a:ext>
                  </a:extLst>
                </a:blip>
                <a:srcRect l="21579" t="54712" r="58018" b="38321"/>
                <a:stretch/>
              </p:blipFill>
              <p:spPr>
                <a:xfrm>
                  <a:off x="5656746" y="5182793"/>
                  <a:ext cx="1307095" cy="207486"/>
                </a:xfrm>
                <a:prstGeom prst="rect">
                  <a:avLst/>
                </a:prstGeom>
              </p:spPr>
            </p:pic>
          </p:grp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7EB3BE57-64FF-4E26-87D6-04FE76B669D5}"/>
                  </a:ext>
                </a:extLst>
              </p:cNvPr>
              <p:cNvSpPr txBox="1"/>
              <p:nvPr/>
            </p:nvSpPr>
            <p:spPr>
              <a:xfrm>
                <a:off x="818194" y="1316650"/>
                <a:ext cx="4716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IE1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8E4A96C2-EB2C-4AAB-9373-7E7FFF94A8C6}"/>
                  </a:ext>
                </a:extLst>
              </p:cNvPr>
              <p:cNvSpPr txBox="1"/>
              <p:nvPr/>
            </p:nvSpPr>
            <p:spPr>
              <a:xfrm>
                <a:off x="2938162" y="1259305"/>
                <a:ext cx="127470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(72-95 </a:t>
                </a:r>
                <a:r>
                  <a:rPr lang="en-US" dirty="0" err="1"/>
                  <a:t>kDa</a:t>
                </a:r>
                <a:r>
                  <a:rPr lang="en-US" dirty="0"/>
                  <a:t>)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F719C658-CC4D-44AF-A044-16A69A26B648}"/>
                  </a:ext>
                </a:extLst>
              </p:cNvPr>
              <p:cNvSpPr txBox="1"/>
              <p:nvPr/>
            </p:nvSpPr>
            <p:spPr>
              <a:xfrm>
                <a:off x="3016407" y="1629520"/>
                <a:ext cx="82907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43 </a:t>
                </a:r>
                <a:r>
                  <a:rPr lang="en-US" dirty="0" err="1"/>
                  <a:t>kDa</a:t>
                </a:r>
                <a:endParaRPr lang="en-US" dirty="0"/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4F1AB76E-0C37-4D87-9BB8-07D3936A9FB6}"/>
                  </a:ext>
                </a:extLst>
              </p:cNvPr>
              <p:cNvSpPr txBox="1"/>
              <p:nvPr/>
            </p:nvSpPr>
            <p:spPr>
              <a:xfrm>
                <a:off x="456942" y="1629520"/>
                <a:ext cx="83869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dirty="0"/>
                  <a:t>β</a:t>
                </a:r>
                <a:r>
                  <a:rPr lang="en-US" dirty="0"/>
                  <a:t>-actin</a:t>
                </a:r>
              </a:p>
            </p:txBody>
          </p:sp>
        </p:grp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CC75D647-8F30-49A8-90DA-D6395DF89F1F}"/>
              </a:ext>
            </a:extLst>
          </p:cNvPr>
          <p:cNvGrpSpPr/>
          <p:nvPr/>
        </p:nvGrpSpPr>
        <p:grpSpPr>
          <a:xfrm>
            <a:off x="8257370" y="1314659"/>
            <a:ext cx="3470548" cy="4510595"/>
            <a:chOff x="8257370" y="1314659"/>
            <a:chExt cx="3470548" cy="4510595"/>
          </a:xfrm>
        </p:grpSpPr>
        <p:graphicFrame>
          <p:nvGraphicFramePr>
            <p:cNvPr id="35" name="Object 34">
              <a:extLst>
                <a:ext uri="{FF2B5EF4-FFF2-40B4-BE49-F238E27FC236}">
                  <a16:creationId xmlns:a16="http://schemas.microsoft.com/office/drawing/2014/main" id="{FB8BC7FE-91F6-4234-9A1D-0CE36EFAD8E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36023153"/>
                </p:ext>
              </p:extLst>
            </p:nvPr>
          </p:nvGraphicFramePr>
          <p:xfrm>
            <a:off x="8768042" y="1999379"/>
            <a:ext cx="2257425" cy="38258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5" imgW="2258051" imgH="3825196" progId="Prism9.Document">
                    <p:embed/>
                  </p:oleObj>
                </mc:Choice>
                <mc:Fallback>
                  <p:oleObj name="Prism 9" r:id="rId15" imgW="2258051" imgH="3825196" progId="Prism9.Document">
                    <p:embed/>
                    <p:pic>
                      <p:nvPicPr>
                        <p:cNvPr id="35" name="Object 34">
                          <a:extLst>
                            <a:ext uri="{FF2B5EF4-FFF2-40B4-BE49-F238E27FC236}">
                              <a16:creationId xmlns:a16="http://schemas.microsoft.com/office/drawing/2014/main" id="{FB8BC7FE-91F6-4234-9A1D-0CE36EFAD8E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8768042" y="1999379"/>
                          <a:ext cx="2257425" cy="38258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5EB3B61A-CF5A-4B53-B63E-E3F0D6588387}"/>
                </a:ext>
              </a:extLst>
            </p:cNvPr>
            <p:cNvGrpSpPr/>
            <p:nvPr/>
          </p:nvGrpSpPr>
          <p:grpSpPr>
            <a:xfrm>
              <a:off x="8257370" y="1314659"/>
              <a:ext cx="3470548" cy="744649"/>
              <a:chOff x="8257370" y="1314659"/>
              <a:chExt cx="3470548" cy="744649"/>
            </a:xfrm>
          </p:grpSpPr>
          <p:pic>
            <p:nvPicPr>
              <p:cNvPr id="32" name="Picture 31">
                <a:extLst>
                  <a:ext uri="{FF2B5EF4-FFF2-40B4-BE49-F238E27FC236}">
                    <a16:creationId xmlns:a16="http://schemas.microsoft.com/office/drawing/2014/main" id="{06F4FD99-0C88-456F-B0D3-56FB9A757B1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7">
                <a:extLst>
                  <a:ext uri="{BEBA8EAE-BF5A-486C-A8C5-ECC9F3942E4B}">
                    <a14:imgProps xmlns:a14="http://schemas.microsoft.com/office/drawing/2010/main">
                      <a14:imgLayer r:embed="rId18">
                        <a14:imgEffect>
                          <a14:brightnessContrast contrast="40000"/>
                        </a14:imgEffect>
                      </a14:imgLayer>
                    </a14:imgProps>
                  </a:ext>
                </a:extLst>
              </a:blip>
              <a:srcRect l="61952" t="30064" r="20961" b="63058"/>
              <a:stretch/>
            </p:blipFill>
            <p:spPr>
              <a:xfrm>
                <a:off x="9088483" y="1416375"/>
                <a:ext cx="1680784" cy="244080"/>
              </a:xfrm>
              <a:prstGeom prst="rect">
                <a:avLst/>
              </a:prstGeom>
            </p:spPr>
          </p:pic>
          <p:pic>
            <p:nvPicPr>
              <p:cNvPr id="33" name="Picture 32">
                <a:extLst>
                  <a:ext uri="{FF2B5EF4-FFF2-40B4-BE49-F238E27FC236}">
                    <a16:creationId xmlns:a16="http://schemas.microsoft.com/office/drawing/2014/main" id="{8BF99F73-6069-4FE5-9754-383F69F047F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9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rcRect l="62550" t="51303" r="18576" b="40322"/>
              <a:stretch/>
            </p:blipFill>
            <p:spPr>
              <a:xfrm>
                <a:off x="9102841" y="1737934"/>
                <a:ext cx="1684169" cy="273417"/>
              </a:xfrm>
              <a:prstGeom prst="rect">
                <a:avLst/>
              </a:prstGeom>
            </p:spPr>
          </p:pic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94A5628F-DFBD-4028-8114-FE95CC261E34}"/>
                  </a:ext>
                </a:extLst>
              </p:cNvPr>
              <p:cNvSpPr txBox="1"/>
              <p:nvPr/>
            </p:nvSpPr>
            <p:spPr>
              <a:xfrm>
                <a:off x="10793790" y="1689976"/>
                <a:ext cx="82907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43 </a:t>
                </a:r>
                <a:r>
                  <a:rPr lang="en-US" dirty="0" err="1"/>
                  <a:t>kDa</a:t>
                </a:r>
                <a:endParaRPr lang="en-US" dirty="0"/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A1F5DC3B-FC68-4ECF-8EDE-EFE7C77F7BCE}"/>
                  </a:ext>
                </a:extLst>
              </p:cNvPr>
              <p:cNvSpPr txBox="1"/>
              <p:nvPr/>
            </p:nvSpPr>
            <p:spPr>
              <a:xfrm>
                <a:off x="8257370" y="1689976"/>
                <a:ext cx="83869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dirty="0"/>
                  <a:t>β</a:t>
                </a:r>
                <a:r>
                  <a:rPr lang="en-US" dirty="0"/>
                  <a:t>-actin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47BE8287-25CD-4024-8327-B55AB5890445}"/>
                  </a:ext>
                </a:extLst>
              </p:cNvPr>
              <p:cNvSpPr txBox="1"/>
              <p:nvPr/>
            </p:nvSpPr>
            <p:spPr>
              <a:xfrm>
                <a:off x="8657221" y="1350609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err="1"/>
                  <a:t>gB</a:t>
                </a:r>
                <a:endParaRPr lang="en-US" dirty="0"/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6B07F656-C494-4867-9371-7DF13C6A9816}"/>
                  </a:ext>
                </a:extLst>
              </p:cNvPr>
              <p:cNvSpPr txBox="1"/>
              <p:nvPr/>
            </p:nvSpPr>
            <p:spPr>
              <a:xfrm>
                <a:off x="10781825" y="1314659"/>
                <a:ext cx="94609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130 </a:t>
                </a:r>
                <a:r>
                  <a:rPr lang="en-US" dirty="0" err="1"/>
                  <a:t>kDa</a:t>
                </a:r>
                <a:endParaRPr lang="en-US" dirty="0"/>
              </a:p>
            </p:txBody>
          </p:sp>
        </p:grpSp>
      </p:grpSp>
      <p:sp>
        <p:nvSpPr>
          <p:cNvPr id="64" name="Rectangle 63">
            <a:extLst>
              <a:ext uri="{FF2B5EF4-FFF2-40B4-BE49-F238E27FC236}">
                <a16:creationId xmlns:a16="http://schemas.microsoft.com/office/drawing/2014/main" id="{AA6CEC30-9B5C-4E70-BB34-BFE99B401A8C}"/>
              </a:ext>
            </a:extLst>
          </p:cNvPr>
          <p:cNvSpPr/>
          <p:nvPr/>
        </p:nvSpPr>
        <p:spPr>
          <a:xfrm>
            <a:off x="4165735" y="770831"/>
            <a:ext cx="28725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6DEE44A3-50A0-4D21-AF5A-A1A9B92AA84D}"/>
              </a:ext>
            </a:extLst>
          </p:cNvPr>
          <p:cNvSpPr/>
          <p:nvPr/>
        </p:nvSpPr>
        <p:spPr>
          <a:xfrm>
            <a:off x="466060" y="770831"/>
            <a:ext cx="28725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BA714ED0-5934-4540-8623-EE4E6162AB12}"/>
              </a:ext>
            </a:extLst>
          </p:cNvPr>
          <p:cNvSpPr/>
          <p:nvPr/>
        </p:nvSpPr>
        <p:spPr>
          <a:xfrm>
            <a:off x="8164000" y="764657"/>
            <a:ext cx="2952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3BF87EF3-59B8-4E3B-933D-B5C0593B0965}"/>
              </a:ext>
            </a:extLst>
          </p:cNvPr>
          <p:cNvSpPr txBox="1"/>
          <p:nvPr/>
        </p:nvSpPr>
        <p:spPr>
          <a:xfrm>
            <a:off x="72087" y="93055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40683327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Group 49">
            <a:extLst>
              <a:ext uri="{FF2B5EF4-FFF2-40B4-BE49-F238E27FC236}">
                <a16:creationId xmlns:a16="http://schemas.microsoft.com/office/drawing/2014/main" id="{427D40AE-8E88-475B-AF1F-C14BD888EFFB}"/>
              </a:ext>
            </a:extLst>
          </p:cNvPr>
          <p:cNvGrpSpPr/>
          <p:nvPr/>
        </p:nvGrpSpPr>
        <p:grpSpPr>
          <a:xfrm>
            <a:off x="1929225" y="202120"/>
            <a:ext cx="6920324" cy="3013075"/>
            <a:chOff x="263080" y="647214"/>
            <a:chExt cx="6920324" cy="3013075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E76A594F-C2E3-4A8B-97FC-5E5ECDEA1D32}"/>
                </a:ext>
              </a:extLst>
            </p:cNvPr>
            <p:cNvGrpSpPr/>
            <p:nvPr/>
          </p:nvGrpSpPr>
          <p:grpSpPr>
            <a:xfrm>
              <a:off x="263080" y="744179"/>
              <a:ext cx="5180592" cy="1497928"/>
              <a:chOff x="1128297" y="726696"/>
              <a:chExt cx="5180592" cy="1497928"/>
            </a:xfrm>
          </p:grpSpPr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32DF58F5-909B-4EA5-B744-2571C43AA89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36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605070" y="1050618"/>
                <a:ext cx="1485853" cy="1174006"/>
              </a:xfrm>
              <a:prstGeom prst="rect">
                <a:avLst/>
              </a:prstGeom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CA5F539F-1502-43B6-B9F9-180CAEF92AB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121648" y="1050618"/>
                <a:ext cx="1584513" cy="1174006"/>
              </a:xfrm>
              <a:prstGeom prst="rect">
                <a:avLst/>
              </a:prstGeom>
            </p:spPr>
          </p:pic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A2974C72-FA76-4E44-9D73-14FE2737A3A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744566" y="1050618"/>
                <a:ext cx="1564323" cy="1174006"/>
              </a:xfrm>
              <a:prstGeom prst="rect">
                <a:avLst/>
              </a:prstGeom>
            </p:spPr>
          </p:pic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CB7BB07F-6F42-4F53-9879-1C899D30EB54}"/>
                  </a:ext>
                </a:extLst>
              </p:cNvPr>
              <p:cNvSpPr txBox="1"/>
              <p:nvPr/>
            </p:nvSpPr>
            <p:spPr>
              <a:xfrm>
                <a:off x="1593946" y="1042297"/>
                <a:ext cx="496510" cy="2110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5A087FDE-0CF0-44AD-8553-D21E8E09C155}"/>
                  </a:ext>
                </a:extLst>
              </p:cNvPr>
              <p:cNvSpPr txBox="1"/>
              <p:nvPr/>
            </p:nvSpPr>
            <p:spPr>
              <a:xfrm>
                <a:off x="1567503" y="1899006"/>
                <a:ext cx="1002197" cy="2372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OS</a:t>
                </a:r>
                <a:r>
                  <a:rPr lang="en-US" sz="1000" b="1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/Hoechst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9E06C6C1-CC18-44C7-A639-415DA030960D}"/>
                  </a:ext>
                </a:extLst>
              </p:cNvPr>
              <p:cNvSpPr txBox="1"/>
              <p:nvPr/>
            </p:nvSpPr>
            <p:spPr>
              <a:xfrm>
                <a:off x="3057743" y="1901812"/>
                <a:ext cx="1002197" cy="2372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OS</a:t>
                </a:r>
                <a:r>
                  <a:rPr lang="en-US" sz="1000" b="1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/Hoechst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11495979-690C-40D2-9738-35B16447E789}"/>
                  </a:ext>
                </a:extLst>
              </p:cNvPr>
              <p:cNvSpPr txBox="1"/>
              <p:nvPr/>
            </p:nvSpPr>
            <p:spPr>
              <a:xfrm>
                <a:off x="4706161" y="1910091"/>
                <a:ext cx="1002197" cy="2372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OS</a:t>
                </a:r>
                <a:r>
                  <a:rPr lang="en-US" sz="1000" b="1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/Hoechst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92B869D1-43A6-4D88-9140-A3C86F00C676}"/>
                  </a:ext>
                </a:extLst>
              </p:cNvPr>
              <p:cNvSpPr txBox="1"/>
              <p:nvPr/>
            </p:nvSpPr>
            <p:spPr>
              <a:xfrm>
                <a:off x="5694988" y="1886836"/>
                <a:ext cx="612668" cy="2372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0 µm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14497FC5-E07B-4522-BC54-60AA3009A448}"/>
                  </a:ext>
                </a:extLst>
              </p:cNvPr>
              <p:cNvSpPr txBox="1"/>
              <p:nvPr/>
            </p:nvSpPr>
            <p:spPr>
              <a:xfrm>
                <a:off x="3267779" y="726696"/>
                <a:ext cx="168667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L1 cardiomyocytes</a:t>
                </a:r>
              </a:p>
            </p:txBody>
          </p:sp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0E5055E1-FB46-40F2-B8CA-8C0AC032FAA9}"/>
                  </a:ext>
                </a:extLst>
              </p:cNvPr>
              <p:cNvSpPr/>
              <p:nvPr/>
            </p:nvSpPr>
            <p:spPr>
              <a:xfrm>
                <a:off x="1128297" y="773619"/>
                <a:ext cx="29527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ED907559-17F0-4C7E-805F-EC8CD0E45A94}"/>
                  </a:ext>
                </a:extLst>
              </p:cNvPr>
              <p:cNvSpPr txBox="1"/>
              <p:nvPr/>
            </p:nvSpPr>
            <p:spPr>
              <a:xfrm>
                <a:off x="4701748" y="1059731"/>
                <a:ext cx="119009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45</a:t>
                </a:r>
                <a:r>
                  <a:rPr lang="en-US" sz="1200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ut</a:t>
                </a:r>
                <a:r>
                  <a:rPr lang="en-US" sz="12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HIM MCMV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B15BE560-03FF-4422-9516-C8EA6A66AAC6}"/>
                  </a:ext>
                </a:extLst>
              </p:cNvPr>
              <p:cNvSpPr txBox="1"/>
              <p:nvPr/>
            </p:nvSpPr>
            <p:spPr>
              <a:xfrm>
                <a:off x="3134166" y="1057600"/>
                <a:ext cx="91648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WT CMV</a:t>
                </a:r>
              </a:p>
            </p:txBody>
          </p:sp>
        </p:grpSp>
        <p:graphicFrame>
          <p:nvGraphicFramePr>
            <p:cNvPr id="28" name="Object 27">
              <a:extLst>
                <a:ext uri="{FF2B5EF4-FFF2-40B4-BE49-F238E27FC236}">
                  <a16:creationId xmlns:a16="http://schemas.microsoft.com/office/drawing/2014/main" id="{F6A96CB8-250D-4428-92AC-74EB730DF36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50127473"/>
                </p:ext>
              </p:extLst>
            </p:nvPr>
          </p:nvGraphicFramePr>
          <p:xfrm>
            <a:off x="5510179" y="647214"/>
            <a:ext cx="1673225" cy="30130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9" imgW="2416511" imgH="4346699" progId="Prism9.Document">
                    <p:embed/>
                  </p:oleObj>
                </mc:Choice>
                <mc:Fallback>
                  <p:oleObj name="Prism 9" r:id="rId9" imgW="2416511" imgH="4346699" progId="Prism9.Document">
                    <p:embed/>
                    <p:pic>
                      <p:nvPicPr>
                        <p:cNvPr id="28" name="Object 27">
                          <a:extLst>
                            <a:ext uri="{FF2B5EF4-FFF2-40B4-BE49-F238E27FC236}">
                              <a16:creationId xmlns:a16="http://schemas.microsoft.com/office/drawing/2014/main" id="{F6A96CB8-250D-4428-92AC-74EB730DF36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5510179" y="647214"/>
                          <a:ext cx="1673225" cy="30130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45" name="TextBox 44">
            <a:extLst>
              <a:ext uri="{FF2B5EF4-FFF2-40B4-BE49-F238E27FC236}">
                <a16:creationId xmlns:a16="http://schemas.microsoft.com/office/drawing/2014/main" id="{9F937FF6-D1E5-48B7-83E2-5221E489BB59}"/>
              </a:ext>
            </a:extLst>
          </p:cNvPr>
          <p:cNvSpPr txBox="1"/>
          <p:nvPr/>
        </p:nvSpPr>
        <p:spPr>
          <a:xfrm>
            <a:off x="84924" y="69305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  <p:grpSp>
        <p:nvGrpSpPr>
          <p:cNvPr id="49" name="Group 48">
            <a:extLst>
              <a:ext uri="{FF2B5EF4-FFF2-40B4-BE49-F238E27FC236}">
                <a16:creationId xmlns:a16="http://schemas.microsoft.com/office/drawing/2014/main" id="{E695F97A-9D06-4E59-AC53-4216682D27D1}"/>
              </a:ext>
            </a:extLst>
          </p:cNvPr>
          <p:cNvGrpSpPr/>
          <p:nvPr/>
        </p:nvGrpSpPr>
        <p:grpSpPr>
          <a:xfrm>
            <a:off x="1929225" y="2819681"/>
            <a:ext cx="7362413" cy="2903257"/>
            <a:chOff x="263080" y="3529956"/>
            <a:chExt cx="7362413" cy="2903257"/>
          </a:xfrm>
        </p:grpSpPr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50BF93C7-E1DA-4922-AF36-D1C2552E5921}"/>
                </a:ext>
              </a:extLst>
            </p:cNvPr>
            <p:cNvGrpSpPr/>
            <p:nvPr/>
          </p:nvGrpSpPr>
          <p:grpSpPr>
            <a:xfrm>
              <a:off x="740493" y="4008359"/>
              <a:ext cx="4682496" cy="1215070"/>
              <a:chOff x="765510" y="2394605"/>
              <a:chExt cx="4682496" cy="1215070"/>
            </a:xfrm>
          </p:grpSpPr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898BA35E-B770-499D-A07C-02BE14A43D44}"/>
                  </a:ext>
                </a:extLst>
              </p:cNvPr>
              <p:cNvGrpSpPr/>
              <p:nvPr/>
            </p:nvGrpSpPr>
            <p:grpSpPr>
              <a:xfrm>
                <a:off x="765510" y="2394605"/>
                <a:ext cx="4682496" cy="1215070"/>
                <a:chOff x="2871923" y="1950225"/>
                <a:chExt cx="4714943" cy="1091115"/>
              </a:xfrm>
            </p:grpSpPr>
            <p:pic>
              <p:nvPicPr>
                <p:cNvPr id="20" name="Picture 19">
                  <a:extLst>
                    <a:ext uri="{FF2B5EF4-FFF2-40B4-BE49-F238E27FC236}">
                      <a16:creationId xmlns:a16="http://schemas.microsoft.com/office/drawing/2014/main" id="{155244D4-BDF1-4DDE-96C2-823DC1008BB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" cstate="print">
                  <a:extLst>
                    <a:ext uri="{BEBA8EAE-BF5A-486C-A8C5-ECC9F3942E4B}">
                      <a14:imgProps xmlns:a14="http://schemas.microsoft.com/office/drawing/2010/main">
                        <a14:imgLayer r:embed="rId12">
                          <a14:imgEffect>
                            <a14:brightnessContrast bright="59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871923" y="1970940"/>
                  <a:ext cx="1496978" cy="1070400"/>
                </a:xfrm>
                <a:prstGeom prst="rect">
                  <a:avLst/>
                </a:prstGeom>
              </p:spPr>
            </p:pic>
            <p:pic>
              <p:nvPicPr>
                <p:cNvPr id="21" name="Picture 20">
                  <a:extLst>
                    <a:ext uri="{FF2B5EF4-FFF2-40B4-BE49-F238E27FC236}">
                      <a16:creationId xmlns:a16="http://schemas.microsoft.com/office/drawing/2014/main" id="{A7371F6A-16D3-4F0A-8A6E-BA956BADC9D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3" cstate="print">
                  <a:extLst>
                    <a:ext uri="{BEBA8EAE-BF5A-486C-A8C5-ECC9F3942E4B}">
                      <a14:imgProps xmlns:a14="http://schemas.microsoft.com/office/drawing/2010/main">
                        <a14:imgLayer r:embed="rId14">
                          <a14:imgEffect>
                            <a14:brightnessContrast bright="56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411393" y="1970940"/>
                  <a:ext cx="1572745" cy="1065273"/>
                </a:xfrm>
                <a:prstGeom prst="rect">
                  <a:avLst/>
                </a:prstGeom>
              </p:spPr>
            </p:pic>
            <p:pic>
              <p:nvPicPr>
                <p:cNvPr id="22" name="Picture 21">
                  <a:extLst>
                    <a:ext uri="{FF2B5EF4-FFF2-40B4-BE49-F238E27FC236}">
                      <a16:creationId xmlns:a16="http://schemas.microsoft.com/office/drawing/2014/main" id="{F0036BEB-75E6-43BB-A394-D480BA33C2F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5" cstate="print">
                  <a:extLst>
                    <a:ext uri="{BEBA8EAE-BF5A-486C-A8C5-ECC9F3942E4B}">
                      <a14:imgProps xmlns:a14="http://schemas.microsoft.com/office/drawing/2010/main">
                        <a14:imgLayer r:embed="rId16">
                          <a14:imgEffect>
                            <a14:brightnessContrast bright="53000" contrast="35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035200" y="1970940"/>
                  <a:ext cx="1551666" cy="1047203"/>
                </a:xfrm>
                <a:prstGeom prst="rect">
                  <a:avLst/>
                </a:prstGeom>
              </p:spPr>
            </p:pic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6B0A62E0-DABC-406B-8877-0B2207D3C024}"/>
                    </a:ext>
                  </a:extLst>
                </p:cNvPr>
                <p:cNvSpPr txBox="1"/>
                <p:nvPr/>
              </p:nvSpPr>
              <p:spPr>
                <a:xfrm>
                  <a:off x="4811788" y="2718644"/>
                  <a:ext cx="1267400" cy="22110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itoSOX</a:t>
                  </a:r>
                  <a:r>
                    <a:rPr lang="en-US" sz="1000" b="1" dirty="0">
                      <a:solidFill>
                        <a:srgbClr val="00B0F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/Hoechst</a:t>
                  </a:r>
                </a:p>
              </p:txBody>
            </p:sp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B27A592E-F277-44E1-A567-61C0B2420F91}"/>
                    </a:ext>
                  </a:extLst>
                </p:cNvPr>
                <p:cNvSpPr txBox="1"/>
                <p:nvPr/>
              </p:nvSpPr>
              <p:spPr>
                <a:xfrm>
                  <a:off x="2883047" y="1950225"/>
                  <a:ext cx="496510" cy="21898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ock</a:t>
                  </a:r>
                </a:p>
              </p:txBody>
            </p:sp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614F0A23-3F7C-4082-BE75-776C405392EA}"/>
                    </a:ext>
                  </a:extLst>
                </p:cNvPr>
                <p:cNvSpPr txBox="1"/>
                <p:nvPr/>
              </p:nvSpPr>
              <p:spPr>
                <a:xfrm>
                  <a:off x="6936895" y="2684586"/>
                  <a:ext cx="61266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0 µm</a:t>
                  </a:r>
                </a:p>
              </p:txBody>
            </p:sp>
          </p:grpSp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5CD59701-5A69-476E-977A-AF56D88F4B3D}"/>
                  </a:ext>
                </a:extLst>
              </p:cNvPr>
              <p:cNvSpPr txBox="1"/>
              <p:nvPr/>
            </p:nvSpPr>
            <p:spPr>
              <a:xfrm>
                <a:off x="2352313" y="2458247"/>
                <a:ext cx="91648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WT CMV</a:t>
                </a:r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88101082-90AA-4F83-8B02-676505CA1EC6}"/>
                  </a:ext>
                </a:extLst>
              </p:cNvPr>
              <p:cNvSpPr txBox="1"/>
              <p:nvPr/>
            </p:nvSpPr>
            <p:spPr>
              <a:xfrm>
                <a:off x="3879395" y="2425984"/>
                <a:ext cx="119009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45</a:t>
                </a:r>
                <a:r>
                  <a:rPr lang="en-US" sz="1200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ut</a:t>
                </a:r>
                <a:r>
                  <a:rPr lang="en-US" sz="12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HIM MCMV</a:t>
                </a:r>
              </a:p>
            </p:txBody>
          </p:sp>
        </p:grpSp>
        <p:graphicFrame>
          <p:nvGraphicFramePr>
            <p:cNvPr id="29" name="Object 28">
              <a:extLst>
                <a:ext uri="{FF2B5EF4-FFF2-40B4-BE49-F238E27FC236}">
                  <a16:creationId xmlns:a16="http://schemas.microsoft.com/office/drawing/2014/main" id="{610BF0C9-091C-4AE5-BA7D-19AB50A64EE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58587200"/>
                </p:ext>
              </p:extLst>
            </p:nvPr>
          </p:nvGraphicFramePr>
          <p:xfrm>
            <a:off x="5577618" y="3667788"/>
            <a:ext cx="2047875" cy="27654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7" imgW="2411829" imgH="4403243" progId="Prism9.Document">
                    <p:embed/>
                  </p:oleObj>
                </mc:Choice>
                <mc:Fallback>
                  <p:oleObj name="Prism 9" r:id="rId17" imgW="2411829" imgH="4403243" progId="Prism9.Document">
                    <p:embed/>
                    <p:pic>
                      <p:nvPicPr>
                        <p:cNvPr id="29" name="Object 28">
                          <a:extLst>
                            <a:ext uri="{FF2B5EF4-FFF2-40B4-BE49-F238E27FC236}">
                              <a16:creationId xmlns:a16="http://schemas.microsoft.com/office/drawing/2014/main" id="{610BF0C9-091C-4AE5-BA7D-19AB50A64EE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5577618" y="3667788"/>
                          <a:ext cx="2047875" cy="27654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EE6616EE-AC16-4F86-B340-39ADF88CA020}"/>
                </a:ext>
              </a:extLst>
            </p:cNvPr>
            <p:cNvSpPr/>
            <p:nvPr/>
          </p:nvSpPr>
          <p:spPr>
            <a:xfrm>
              <a:off x="263080" y="3529956"/>
              <a:ext cx="29527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4926457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84924" y="69305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</a:p>
        </p:txBody>
      </p:sp>
      <p:sp>
        <p:nvSpPr>
          <p:cNvPr id="31" name="Rectangle 30"/>
          <p:cNvSpPr/>
          <p:nvPr/>
        </p:nvSpPr>
        <p:spPr>
          <a:xfrm>
            <a:off x="297528" y="689399"/>
            <a:ext cx="28725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4E062018-B057-46CE-9E7E-2EF942D3BAC9}"/>
              </a:ext>
            </a:extLst>
          </p:cNvPr>
          <p:cNvSpPr/>
          <p:nvPr/>
        </p:nvSpPr>
        <p:spPr>
          <a:xfrm>
            <a:off x="3950534" y="642753"/>
            <a:ext cx="28725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83" name="Rectangle 182">
            <a:extLst>
              <a:ext uri="{FF2B5EF4-FFF2-40B4-BE49-F238E27FC236}">
                <a16:creationId xmlns:a16="http://schemas.microsoft.com/office/drawing/2014/main" id="{FA4FB1B5-D781-4CCC-8F49-C6BE888B9BC4}"/>
              </a:ext>
            </a:extLst>
          </p:cNvPr>
          <p:cNvSpPr/>
          <p:nvPr/>
        </p:nvSpPr>
        <p:spPr>
          <a:xfrm>
            <a:off x="6952597" y="707894"/>
            <a:ext cx="2952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09CAEEFA-A884-4F6F-841E-E9AB717F5568}"/>
              </a:ext>
            </a:extLst>
          </p:cNvPr>
          <p:cNvGrpSpPr/>
          <p:nvPr/>
        </p:nvGrpSpPr>
        <p:grpSpPr>
          <a:xfrm>
            <a:off x="7455027" y="733026"/>
            <a:ext cx="4054348" cy="3697687"/>
            <a:chOff x="7455027" y="733026"/>
            <a:chExt cx="4054348" cy="3697687"/>
          </a:xfrm>
        </p:grpSpPr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3208EEB3-E5B2-47D0-9D13-5C2192F54517}"/>
                </a:ext>
              </a:extLst>
            </p:cNvPr>
            <p:cNvGrpSpPr/>
            <p:nvPr/>
          </p:nvGrpSpPr>
          <p:grpSpPr>
            <a:xfrm>
              <a:off x="7455027" y="733026"/>
              <a:ext cx="3922210" cy="1416611"/>
              <a:chOff x="822104" y="3491459"/>
              <a:chExt cx="4635459" cy="1580784"/>
            </a:xfrm>
          </p:grpSpPr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0E036A38-B777-4DB5-B6BB-33D85C462A51}"/>
                  </a:ext>
                </a:extLst>
              </p:cNvPr>
              <p:cNvSpPr txBox="1"/>
              <p:nvPr/>
            </p:nvSpPr>
            <p:spPr>
              <a:xfrm>
                <a:off x="2403767" y="3491459"/>
                <a:ext cx="1998845" cy="3182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L1 cardiomyocytes</a:t>
                </a:r>
              </a:p>
            </p:txBody>
          </p:sp>
          <p:grpSp>
            <p:nvGrpSpPr>
              <p:cNvPr id="2" name="Group 1">
                <a:extLst>
                  <a:ext uri="{FF2B5EF4-FFF2-40B4-BE49-F238E27FC236}">
                    <a16:creationId xmlns:a16="http://schemas.microsoft.com/office/drawing/2014/main" id="{BF5A8F8E-966B-4F1D-9CD9-5681C0081F2F}"/>
                  </a:ext>
                </a:extLst>
              </p:cNvPr>
              <p:cNvGrpSpPr/>
              <p:nvPr/>
            </p:nvGrpSpPr>
            <p:grpSpPr>
              <a:xfrm>
                <a:off x="822104" y="3853307"/>
                <a:ext cx="4635459" cy="1218936"/>
                <a:chOff x="5194956" y="837949"/>
                <a:chExt cx="4635459" cy="1218936"/>
              </a:xfrm>
            </p:grpSpPr>
            <p:pic>
              <p:nvPicPr>
                <p:cNvPr id="145" name="Picture 144">
                  <a:extLst>
                    <a:ext uri="{FF2B5EF4-FFF2-40B4-BE49-F238E27FC236}">
                      <a16:creationId xmlns:a16="http://schemas.microsoft.com/office/drawing/2014/main" id="{739D93B9-AF17-4AF2-854A-DF7329A0ABE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BEBA8EAE-BF5A-486C-A8C5-ECC9F3942E4B}">
                      <a14:imgProps xmlns:a14="http://schemas.microsoft.com/office/drawing/2010/main">
                        <a14:imgLayer r:embed="rId4">
                          <a14:imgEffect>
                            <a14:brightnessContrast bright="4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224952" y="837950"/>
                  <a:ext cx="1551667" cy="1109507"/>
                </a:xfrm>
                <a:prstGeom prst="rect">
                  <a:avLst/>
                </a:prstGeom>
              </p:spPr>
            </p:pic>
            <p:pic>
              <p:nvPicPr>
                <p:cNvPr id="146" name="Picture 145">
                  <a:extLst>
                    <a:ext uri="{FF2B5EF4-FFF2-40B4-BE49-F238E27FC236}">
                      <a16:creationId xmlns:a16="http://schemas.microsoft.com/office/drawing/2014/main" id="{E1E8EFF6-8193-46AA-8F2F-A12F550026C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 cstate="print">
                  <a:extLst>
                    <a:ext uri="{BEBA8EAE-BF5A-486C-A8C5-ECC9F3942E4B}">
                      <a14:imgProps xmlns:a14="http://schemas.microsoft.com/office/drawing/2010/main">
                        <a14:imgLayer r:embed="rId6">
                          <a14:imgEffect>
                            <a14:brightnessContrast bright="4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790270" y="842279"/>
                  <a:ext cx="1551667" cy="1105178"/>
                </a:xfrm>
                <a:prstGeom prst="rect">
                  <a:avLst/>
                </a:prstGeom>
              </p:spPr>
            </p:pic>
            <p:pic>
              <p:nvPicPr>
                <p:cNvPr id="147" name="Picture 146">
                  <a:extLst>
                    <a:ext uri="{FF2B5EF4-FFF2-40B4-BE49-F238E27FC236}">
                      <a16:creationId xmlns:a16="http://schemas.microsoft.com/office/drawing/2014/main" id="{7DB12F44-2CBC-414C-A32A-0C1A8A1F193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 cstate="print">
                  <a:extLst>
                    <a:ext uri="{BEBA8EAE-BF5A-486C-A8C5-ECC9F3942E4B}">
                      <a14:imgProps xmlns:a14="http://schemas.microsoft.com/office/drawing/2010/main">
                        <a14:imgLayer r:embed="rId8">
                          <a14:imgEffect>
                            <a14:brightnessContrast bright="4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382990" y="837951"/>
                  <a:ext cx="1447425" cy="1100502"/>
                </a:xfrm>
                <a:prstGeom prst="rect">
                  <a:avLst/>
                </a:prstGeom>
              </p:spPr>
            </p:pic>
            <p:sp>
              <p:nvSpPr>
                <p:cNvPr id="148" name="TextBox 147">
                  <a:extLst>
                    <a:ext uri="{FF2B5EF4-FFF2-40B4-BE49-F238E27FC236}">
                      <a16:creationId xmlns:a16="http://schemas.microsoft.com/office/drawing/2014/main" id="{FB782309-4241-4767-A043-FF1E327EB7C2}"/>
                    </a:ext>
                  </a:extLst>
                </p:cNvPr>
                <p:cNvSpPr txBox="1"/>
                <p:nvPr/>
              </p:nvSpPr>
              <p:spPr>
                <a:xfrm>
                  <a:off x="5194956" y="1581271"/>
                  <a:ext cx="1023090" cy="27475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 err="1">
                      <a:solidFill>
                        <a:srgbClr val="00B05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itotracker</a:t>
                  </a:r>
                  <a:endParaRPr lang="en-US" sz="1000" b="1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9" name="TextBox 148">
                  <a:extLst>
                    <a:ext uri="{FF2B5EF4-FFF2-40B4-BE49-F238E27FC236}">
                      <a16:creationId xmlns:a16="http://schemas.microsoft.com/office/drawing/2014/main" id="{365DDBBD-1F84-4BD0-B288-FF81C7218C81}"/>
                    </a:ext>
                  </a:extLst>
                </p:cNvPr>
                <p:cNvSpPr txBox="1"/>
                <p:nvPr/>
              </p:nvSpPr>
              <p:spPr>
                <a:xfrm>
                  <a:off x="6749217" y="1646164"/>
                  <a:ext cx="1027772" cy="27475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 err="1">
                      <a:solidFill>
                        <a:srgbClr val="00B05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itotracker</a:t>
                  </a:r>
                  <a:endParaRPr lang="en-US" sz="1000" b="1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0" name="TextBox 149">
                  <a:extLst>
                    <a:ext uri="{FF2B5EF4-FFF2-40B4-BE49-F238E27FC236}">
                      <a16:creationId xmlns:a16="http://schemas.microsoft.com/office/drawing/2014/main" id="{BA0C3441-E70E-4703-B2D3-9867161E6DEF}"/>
                    </a:ext>
                  </a:extLst>
                </p:cNvPr>
                <p:cNvSpPr txBox="1"/>
                <p:nvPr/>
              </p:nvSpPr>
              <p:spPr>
                <a:xfrm>
                  <a:off x="8341937" y="1610406"/>
                  <a:ext cx="984925" cy="44647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 err="1">
                      <a:solidFill>
                        <a:srgbClr val="00B05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itotracker</a:t>
                  </a:r>
                  <a:endParaRPr lang="en-US" sz="1000" b="1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1" name="TextBox 150">
                  <a:extLst>
                    <a:ext uri="{FF2B5EF4-FFF2-40B4-BE49-F238E27FC236}">
                      <a16:creationId xmlns:a16="http://schemas.microsoft.com/office/drawing/2014/main" id="{9163B54E-B4E5-4A37-9835-16F470FEA688}"/>
                    </a:ext>
                  </a:extLst>
                </p:cNvPr>
                <p:cNvSpPr txBox="1"/>
                <p:nvPr/>
              </p:nvSpPr>
              <p:spPr>
                <a:xfrm>
                  <a:off x="5224952" y="837949"/>
                  <a:ext cx="661573" cy="3091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ock</a:t>
                  </a:r>
                </a:p>
              </p:txBody>
            </p:sp>
            <p:sp>
              <p:nvSpPr>
                <p:cNvPr id="152" name="TextBox 151">
                  <a:extLst>
                    <a:ext uri="{FF2B5EF4-FFF2-40B4-BE49-F238E27FC236}">
                      <a16:creationId xmlns:a16="http://schemas.microsoft.com/office/drawing/2014/main" id="{D9A3EFCC-6838-49AA-8855-2B4E8BCEA108}"/>
                    </a:ext>
                  </a:extLst>
                </p:cNvPr>
                <p:cNvSpPr txBox="1"/>
                <p:nvPr/>
              </p:nvSpPr>
              <p:spPr>
                <a:xfrm>
                  <a:off x="8351505" y="867821"/>
                  <a:ext cx="1406517" cy="51516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45</a:t>
                  </a:r>
                  <a:r>
                    <a:rPr lang="en-US" sz="1200" i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ut</a:t>
                  </a:r>
                  <a:r>
                    <a:rPr lang="en-US" sz="12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RHIM</a:t>
                  </a:r>
                </a:p>
                <a:p>
                  <a:r>
                    <a:rPr lang="en-US" sz="12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CMV</a:t>
                  </a:r>
                </a:p>
              </p:txBody>
            </p:sp>
            <p:sp>
              <p:nvSpPr>
                <p:cNvPr id="153" name="TextBox 152">
                  <a:extLst>
                    <a:ext uri="{FF2B5EF4-FFF2-40B4-BE49-F238E27FC236}">
                      <a16:creationId xmlns:a16="http://schemas.microsoft.com/office/drawing/2014/main" id="{768D9893-2BCB-439A-889B-626891FD07B5}"/>
                    </a:ext>
                  </a:extLst>
                </p:cNvPr>
                <p:cNvSpPr txBox="1"/>
                <p:nvPr/>
              </p:nvSpPr>
              <p:spPr>
                <a:xfrm>
                  <a:off x="6790269" y="873933"/>
                  <a:ext cx="1161820" cy="3091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WT MCMV</a:t>
                  </a:r>
                </a:p>
              </p:txBody>
            </p:sp>
          </p:grpSp>
        </p:grpSp>
        <p:graphicFrame>
          <p:nvGraphicFramePr>
            <p:cNvPr id="11" name="Object 10">
              <a:extLst>
                <a:ext uri="{FF2B5EF4-FFF2-40B4-BE49-F238E27FC236}">
                  <a16:creationId xmlns:a16="http://schemas.microsoft.com/office/drawing/2014/main" id="{68490AC2-4184-4763-A9DE-08A574ABA48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05555422"/>
                </p:ext>
              </p:extLst>
            </p:nvPr>
          </p:nvGraphicFramePr>
          <p:xfrm>
            <a:off x="9680575" y="2046288"/>
            <a:ext cx="1828800" cy="23844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9" imgW="2411829" imgH="4392439" progId="Prism9.Document">
                    <p:embed/>
                  </p:oleObj>
                </mc:Choice>
                <mc:Fallback>
                  <p:oleObj name="Prism 9" r:id="rId9" imgW="2411829" imgH="4392439" progId="Prism9.Document">
                    <p:embed/>
                    <p:pic>
                      <p:nvPicPr>
                        <p:cNvPr id="11" name="Object 10">
                          <a:extLst>
                            <a:ext uri="{FF2B5EF4-FFF2-40B4-BE49-F238E27FC236}">
                              <a16:creationId xmlns:a16="http://schemas.microsoft.com/office/drawing/2014/main" id="{68490AC2-4184-4763-A9DE-08A574ABA48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9680575" y="2046288"/>
                          <a:ext cx="1828800" cy="23844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5719AD18-AC5B-45EC-8680-954182F44F33}"/>
              </a:ext>
            </a:extLst>
          </p:cNvPr>
          <p:cNvGrpSpPr/>
          <p:nvPr/>
        </p:nvGrpSpPr>
        <p:grpSpPr>
          <a:xfrm>
            <a:off x="628068" y="994618"/>
            <a:ext cx="3072728" cy="2708231"/>
            <a:chOff x="628068" y="994618"/>
            <a:chExt cx="3072728" cy="2708231"/>
          </a:xfrm>
        </p:grpSpPr>
        <p:grpSp>
          <p:nvGrpSpPr>
            <p:cNvPr id="26" name="Group 25"/>
            <p:cNvGrpSpPr/>
            <p:nvPr/>
          </p:nvGrpSpPr>
          <p:grpSpPr>
            <a:xfrm>
              <a:off x="628068" y="994618"/>
              <a:ext cx="3072728" cy="588522"/>
              <a:chOff x="1323658" y="1295020"/>
              <a:chExt cx="3072728" cy="588522"/>
            </a:xfrm>
          </p:grpSpPr>
          <p:pic>
            <p:nvPicPr>
              <p:cNvPr id="17" name="Picture 16"/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contrast="20000"/>
                        </a14:imgEffect>
                      </a14:imgLayer>
                    </a14:imgProps>
                  </a:ext>
                </a:extLst>
              </a:blip>
              <a:srcRect l="44206" t="34215" r="38149" b="60040"/>
              <a:stretch/>
            </p:blipFill>
            <p:spPr>
              <a:xfrm>
                <a:off x="2014873" y="1295020"/>
                <a:ext cx="1737332" cy="279401"/>
              </a:xfrm>
              <a:prstGeom prst="rect">
                <a:avLst/>
              </a:prstGeom>
            </p:spPr>
          </p:pic>
          <p:pic>
            <p:nvPicPr>
              <p:cNvPr id="18" name="Picture 17"/>
              <p:cNvPicPr>
                <a:picLocks noChangeAspect="1"/>
              </p:cNvPicPr>
              <p:nvPr/>
            </p:nvPicPr>
            <p:blipFill rotWithShape="1">
              <a:blip r:embed="rId13">
                <a:extLst>
                  <a:ext uri="{BEBA8EAE-BF5A-486C-A8C5-ECC9F3942E4B}">
                    <a14:imgProps xmlns:a14="http://schemas.microsoft.com/office/drawing/2010/main">
                      <a14:imgLayer r:embed="rId14">
                        <a14:imgEffect>
                          <a14:brightnessContrast contrast="20000"/>
                        </a14:imgEffect>
                      </a14:imgLayer>
                    </a14:imgProps>
                  </a:ext>
                </a:extLst>
              </a:blip>
              <a:srcRect l="45114" t="26416" r="38622" b="68393"/>
              <a:stretch/>
            </p:blipFill>
            <p:spPr>
              <a:xfrm>
                <a:off x="2014873" y="1612608"/>
                <a:ext cx="1726598" cy="270934"/>
              </a:xfrm>
              <a:prstGeom prst="rect">
                <a:avLst/>
              </a:prstGeom>
            </p:spPr>
          </p:pic>
          <p:sp>
            <p:nvSpPr>
              <p:cNvPr id="19" name="TextBox 18"/>
              <p:cNvSpPr txBox="1"/>
              <p:nvPr/>
            </p:nvSpPr>
            <p:spPr>
              <a:xfrm>
                <a:off x="3718280" y="1603235"/>
                <a:ext cx="67037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3 </a:t>
                </a:r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3726010" y="1306795"/>
                <a:ext cx="67037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95 </a:t>
                </a:r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1372435" y="1301752"/>
                <a:ext cx="69281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GC1</a:t>
                </a:r>
                <a:r>
                  <a:rPr lang="el-G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1323658" y="1583081"/>
                <a:ext cx="69121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 actin</a:t>
                </a:r>
              </a:p>
            </p:txBody>
          </p:sp>
        </p:grpSp>
        <p:graphicFrame>
          <p:nvGraphicFramePr>
            <p:cNvPr id="81" name="Object 80">
              <a:extLst>
                <a:ext uri="{FF2B5EF4-FFF2-40B4-BE49-F238E27FC236}">
                  <a16:creationId xmlns:a16="http://schemas.microsoft.com/office/drawing/2014/main" id="{102F7D1B-5C2E-4CBF-80B4-D496BB4FA9D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44929723"/>
                </p:ext>
              </p:extLst>
            </p:nvPr>
          </p:nvGraphicFramePr>
          <p:xfrm>
            <a:off x="952503" y="1493049"/>
            <a:ext cx="1966913" cy="22098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5" imgW="3723083" imgH="4189672" progId="Prism9.Document">
                    <p:embed/>
                  </p:oleObj>
                </mc:Choice>
                <mc:Fallback>
                  <p:oleObj name="Prism 9" r:id="rId15" imgW="3723083" imgH="4189672" progId="Prism9.Document">
                    <p:embed/>
                    <p:pic>
                      <p:nvPicPr>
                        <p:cNvPr id="81" name="Object 80">
                          <a:extLst>
                            <a:ext uri="{FF2B5EF4-FFF2-40B4-BE49-F238E27FC236}">
                              <a16:creationId xmlns:a16="http://schemas.microsoft.com/office/drawing/2014/main" id="{102F7D1B-5C2E-4CBF-80B4-D496BB4FA9D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952503" y="1493049"/>
                          <a:ext cx="1966913" cy="22098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1CED79EB-D7AB-445B-9FFC-250284303E01}"/>
              </a:ext>
            </a:extLst>
          </p:cNvPr>
          <p:cNvGrpSpPr/>
          <p:nvPr/>
        </p:nvGrpSpPr>
        <p:grpSpPr>
          <a:xfrm>
            <a:off x="3875034" y="896367"/>
            <a:ext cx="2870407" cy="2862963"/>
            <a:chOff x="3875034" y="896367"/>
            <a:chExt cx="2870407" cy="2862963"/>
          </a:xfrm>
        </p:grpSpPr>
        <p:grpSp>
          <p:nvGrpSpPr>
            <p:cNvPr id="45" name="Group 44"/>
            <p:cNvGrpSpPr/>
            <p:nvPr/>
          </p:nvGrpSpPr>
          <p:grpSpPr>
            <a:xfrm>
              <a:off x="3875034" y="896367"/>
              <a:ext cx="2870407" cy="658939"/>
              <a:chOff x="2779295" y="1831938"/>
              <a:chExt cx="2870407" cy="658939"/>
            </a:xfrm>
          </p:grpSpPr>
          <p:pic>
            <p:nvPicPr>
              <p:cNvPr id="47" name="Picture 46"/>
              <p:cNvPicPr>
                <a:picLocks noChangeAspect="1"/>
              </p:cNvPicPr>
              <p:nvPr/>
            </p:nvPicPr>
            <p:blipFill rotWithShape="1">
              <a:blip r:embed="rId17"/>
              <a:srcRect l="60143" t="48264" r="20832" b="42971"/>
              <a:stretch/>
            </p:blipFill>
            <p:spPr>
              <a:xfrm>
                <a:off x="3429183" y="1831938"/>
                <a:ext cx="1550143" cy="352309"/>
              </a:xfrm>
              <a:prstGeom prst="rect">
                <a:avLst/>
              </a:prstGeom>
            </p:spPr>
          </p:pic>
          <p:pic>
            <p:nvPicPr>
              <p:cNvPr id="48" name="Picture 47"/>
              <p:cNvPicPr>
                <a:picLocks noChangeAspect="1"/>
              </p:cNvPicPr>
              <p:nvPr/>
            </p:nvPicPr>
            <p:blipFill rotWithShape="1">
              <a:blip r:embed="rId18"/>
              <a:srcRect l="62265" t="37304" r="20524" b="57046"/>
              <a:stretch/>
            </p:blipFill>
            <p:spPr>
              <a:xfrm>
                <a:off x="3429183" y="2213878"/>
                <a:ext cx="1550143" cy="247368"/>
              </a:xfrm>
              <a:prstGeom prst="rect">
                <a:avLst/>
              </a:prstGeom>
            </p:spPr>
          </p:pic>
          <p:sp>
            <p:nvSpPr>
              <p:cNvPr id="49" name="TextBox 48"/>
              <p:cNvSpPr txBox="1"/>
              <p:nvPr/>
            </p:nvSpPr>
            <p:spPr>
              <a:xfrm>
                <a:off x="4979326" y="1844546"/>
                <a:ext cx="67037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22 </a:t>
                </a:r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4979326" y="2213878"/>
                <a:ext cx="67037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3 </a:t>
                </a:r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2779295" y="2199062"/>
                <a:ext cx="69121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 actin</a:t>
                </a: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2832994" y="1898802"/>
                <a:ext cx="59618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TFAM</a:t>
                </a:r>
              </a:p>
            </p:txBody>
          </p:sp>
        </p:grpSp>
        <p:graphicFrame>
          <p:nvGraphicFramePr>
            <p:cNvPr id="82" name="Object 81">
              <a:extLst>
                <a:ext uri="{FF2B5EF4-FFF2-40B4-BE49-F238E27FC236}">
                  <a16:creationId xmlns:a16="http://schemas.microsoft.com/office/drawing/2014/main" id="{4BDF7267-A986-4980-9236-DD7A1B3A39C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096347276"/>
                </p:ext>
              </p:extLst>
            </p:nvPr>
          </p:nvGraphicFramePr>
          <p:xfrm>
            <a:off x="4251132" y="1473330"/>
            <a:ext cx="1870075" cy="2286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9" imgW="3576508" imgH="4365067" progId="Prism9.Document">
                    <p:embed/>
                  </p:oleObj>
                </mc:Choice>
                <mc:Fallback>
                  <p:oleObj name="Prism 9" r:id="rId19" imgW="3576508" imgH="4365067" progId="Prism9.Document">
                    <p:embed/>
                    <p:pic>
                      <p:nvPicPr>
                        <p:cNvPr id="82" name="Object 81">
                          <a:extLst>
                            <a:ext uri="{FF2B5EF4-FFF2-40B4-BE49-F238E27FC236}">
                              <a16:creationId xmlns:a16="http://schemas.microsoft.com/office/drawing/2014/main" id="{4BDF7267-A986-4980-9236-DD7A1B3A39C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0"/>
                        <a:stretch>
                          <a:fillRect/>
                        </a:stretch>
                      </p:blipFill>
                      <p:spPr>
                        <a:xfrm>
                          <a:off x="4251132" y="1473330"/>
                          <a:ext cx="1870075" cy="2286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309752166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>
            <a:extLst>
              <a:ext uri="{FF2B5EF4-FFF2-40B4-BE49-F238E27FC236}">
                <a16:creationId xmlns:a16="http://schemas.microsoft.com/office/drawing/2014/main" id="{F7B8BE74-67CE-40A9-A9CD-083FE8340466}"/>
              </a:ext>
            </a:extLst>
          </p:cNvPr>
          <p:cNvGrpSpPr/>
          <p:nvPr/>
        </p:nvGrpSpPr>
        <p:grpSpPr>
          <a:xfrm>
            <a:off x="1542985" y="1096274"/>
            <a:ext cx="2541165" cy="3199966"/>
            <a:chOff x="474349" y="1404746"/>
            <a:chExt cx="2541165" cy="3199966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D2E0BC75-782D-444B-B846-8C4A20C6AE2A}"/>
                </a:ext>
              </a:extLst>
            </p:cNvPr>
            <p:cNvGrpSpPr/>
            <p:nvPr/>
          </p:nvGrpSpPr>
          <p:grpSpPr>
            <a:xfrm>
              <a:off x="474349" y="1404747"/>
              <a:ext cx="1272781" cy="950531"/>
              <a:chOff x="474349" y="1404747"/>
              <a:chExt cx="1272781" cy="950531"/>
            </a:xfrm>
          </p:grpSpPr>
          <p:pic>
            <p:nvPicPr>
              <p:cNvPr id="16" name="Picture 15">
                <a:extLst>
                  <a:ext uri="{FF2B5EF4-FFF2-40B4-BE49-F238E27FC236}">
                    <a16:creationId xmlns:a16="http://schemas.microsoft.com/office/drawing/2014/main" id="{21B7605A-AFD1-4D41-89D8-D9EA689D334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29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22603" y="1404747"/>
                <a:ext cx="1224527" cy="950531"/>
              </a:xfrm>
              <a:prstGeom prst="rect">
                <a:avLst/>
              </a:prstGeom>
            </p:spPr>
          </p:pic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A7AA86FF-85EA-464D-B7D2-97022ABD54BA}"/>
                  </a:ext>
                </a:extLst>
              </p:cNvPr>
              <p:cNvSpPr txBox="1"/>
              <p:nvPr/>
            </p:nvSpPr>
            <p:spPr>
              <a:xfrm>
                <a:off x="474349" y="1404747"/>
                <a:ext cx="57885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</a:p>
            </p:txBody>
          </p:sp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7AE67717-F76A-46F6-8694-320DA7273BA3}"/>
                </a:ext>
              </a:extLst>
            </p:cNvPr>
            <p:cNvGrpSpPr/>
            <p:nvPr/>
          </p:nvGrpSpPr>
          <p:grpSpPr>
            <a:xfrm>
              <a:off x="1735943" y="1404746"/>
              <a:ext cx="1279571" cy="950532"/>
              <a:chOff x="1735943" y="1404746"/>
              <a:chExt cx="1279571" cy="950532"/>
            </a:xfrm>
          </p:grpSpPr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C9EA3A81-54C3-42F5-9E7F-0B9CC85D0A0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790987" y="1404747"/>
                <a:ext cx="1224527" cy="950531"/>
              </a:xfrm>
              <a:prstGeom prst="rect">
                <a:avLst/>
              </a:prstGeom>
            </p:spPr>
          </p:pic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71D9256F-7756-4B45-9616-E9233EC7C2F7}"/>
                  </a:ext>
                </a:extLst>
              </p:cNvPr>
              <p:cNvSpPr txBox="1"/>
              <p:nvPr/>
            </p:nvSpPr>
            <p:spPr>
              <a:xfrm>
                <a:off x="1735943" y="1404746"/>
                <a:ext cx="11755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T MCMV</a:t>
                </a:r>
              </a:p>
            </p:txBody>
          </p:sp>
        </p:grpSp>
        <p:graphicFrame>
          <p:nvGraphicFramePr>
            <p:cNvPr id="19" name="Object 18">
              <a:extLst>
                <a:ext uri="{FF2B5EF4-FFF2-40B4-BE49-F238E27FC236}">
                  <a16:creationId xmlns:a16="http://schemas.microsoft.com/office/drawing/2014/main" id="{2AE379ED-F3A7-4363-9326-041BF801467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26583989"/>
                </p:ext>
              </p:extLst>
            </p:nvPr>
          </p:nvGraphicFramePr>
          <p:xfrm>
            <a:off x="552663" y="2355278"/>
            <a:ext cx="2388934" cy="224943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6" imgW="3517085" imgH="3311616" progId="Prism9.Document">
                    <p:embed/>
                  </p:oleObj>
                </mc:Choice>
                <mc:Fallback>
                  <p:oleObj name="Prism 9" r:id="rId6" imgW="3517085" imgH="3311616" progId="Prism9.Document">
                    <p:embed/>
                    <p:pic>
                      <p:nvPicPr>
                        <p:cNvPr id="19" name="Object 18">
                          <a:extLst>
                            <a:ext uri="{FF2B5EF4-FFF2-40B4-BE49-F238E27FC236}">
                              <a16:creationId xmlns:a16="http://schemas.microsoft.com/office/drawing/2014/main" id="{2AE379ED-F3A7-4363-9326-041BF801467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552663" y="2355278"/>
                          <a:ext cx="2388934" cy="224943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EF2B0480-A93F-47FA-B47A-7009788EE6B5}"/>
              </a:ext>
            </a:extLst>
          </p:cNvPr>
          <p:cNvSpPr txBox="1"/>
          <p:nvPr/>
        </p:nvSpPr>
        <p:spPr>
          <a:xfrm>
            <a:off x="241248" y="284241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</a:p>
        </p:txBody>
      </p:sp>
    </p:spTree>
    <p:extLst>
      <p:ext uri="{BB962C8B-B14F-4D97-AF65-F5344CB8AC3E}">
        <p14:creationId xmlns:p14="http://schemas.microsoft.com/office/powerpoint/2010/main" val="303101169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6F6ABD7-C00B-41E2-ABBC-490D7575E853}"/>
              </a:ext>
            </a:extLst>
          </p:cNvPr>
          <p:cNvSpPr txBox="1"/>
          <p:nvPr/>
        </p:nvSpPr>
        <p:spPr>
          <a:xfrm>
            <a:off x="241248" y="284241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7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4D3759AF-A0D2-4E55-B695-4BE517379EDB}"/>
              </a:ext>
            </a:extLst>
          </p:cNvPr>
          <p:cNvGrpSpPr/>
          <p:nvPr/>
        </p:nvGrpSpPr>
        <p:grpSpPr>
          <a:xfrm>
            <a:off x="684638" y="1439573"/>
            <a:ext cx="3155355" cy="2673949"/>
            <a:chOff x="599607" y="4441618"/>
            <a:chExt cx="3155355" cy="2673949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E4805178-903C-4221-803D-1D91C5C4DDC1}"/>
                </a:ext>
              </a:extLst>
            </p:cNvPr>
            <p:cNvGrpSpPr/>
            <p:nvPr/>
          </p:nvGrpSpPr>
          <p:grpSpPr>
            <a:xfrm>
              <a:off x="1250497" y="4486982"/>
              <a:ext cx="1755241" cy="492840"/>
              <a:chOff x="2059622" y="3434861"/>
              <a:chExt cx="1860375" cy="469375"/>
            </a:xfrm>
          </p:grpSpPr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F8E2AF6C-45E3-4597-94EC-2B3AF71051D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rcRect l="25011" t="27003" r="57319" b="69072"/>
              <a:stretch/>
            </p:blipFill>
            <p:spPr>
              <a:xfrm>
                <a:off x="2059622" y="3434861"/>
                <a:ext cx="1860375" cy="204077"/>
              </a:xfrm>
              <a:prstGeom prst="rect">
                <a:avLst/>
              </a:prstGeom>
            </p:spPr>
          </p:pic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E9F3BEF1-C32B-44E6-8969-B4FC3BB384A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rcRect l="27370" t="26895" r="55244" b="68849"/>
              <a:stretch/>
            </p:blipFill>
            <p:spPr>
              <a:xfrm>
                <a:off x="2059622" y="3680301"/>
                <a:ext cx="1860375" cy="223935"/>
              </a:xfrm>
              <a:prstGeom prst="rect">
                <a:avLst/>
              </a:prstGeom>
            </p:spPr>
          </p:pic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724A4A0-D9AE-474A-8A59-C5AF6135BB11}"/>
                </a:ext>
              </a:extLst>
            </p:cNvPr>
            <p:cNvSpPr txBox="1"/>
            <p:nvPr/>
          </p:nvSpPr>
          <p:spPr>
            <a:xfrm>
              <a:off x="2981992" y="4703947"/>
              <a:ext cx="7729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(43 kDa)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2128009-90A6-4F39-AC7F-F29C879C61E5}"/>
                </a:ext>
              </a:extLst>
            </p:cNvPr>
            <p:cNvSpPr txBox="1"/>
            <p:nvPr/>
          </p:nvSpPr>
          <p:spPr>
            <a:xfrm>
              <a:off x="2981992" y="4441618"/>
              <a:ext cx="7729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(42 kDa)</a:t>
              </a:r>
            </a:p>
          </p:txBody>
        </p:sp>
        <p:graphicFrame>
          <p:nvGraphicFramePr>
            <p:cNvPr id="8" name="Object 7">
              <a:extLst>
                <a:ext uri="{FF2B5EF4-FFF2-40B4-BE49-F238E27FC236}">
                  <a16:creationId xmlns:a16="http://schemas.microsoft.com/office/drawing/2014/main" id="{16A2AA72-7028-441E-8205-1F9C3B286C1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64693653"/>
                </p:ext>
              </p:extLst>
            </p:nvPr>
          </p:nvGraphicFramePr>
          <p:xfrm>
            <a:off x="1063081" y="4932755"/>
            <a:ext cx="2173288" cy="21828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7" imgW="3213851" imgH="3222062" progId="Prism9.Document">
                    <p:embed/>
                  </p:oleObj>
                </mc:Choice>
                <mc:Fallback>
                  <p:oleObj name="Prism 9" r:id="rId7" imgW="3213851" imgH="3222062" progId="Prism9.Document">
                    <p:embed/>
                    <p:pic>
                      <p:nvPicPr>
                        <p:cNvPr id="8" name="Object 7">
                          <a:extLst>
                            <a:ext uri="{FF2B5EF4-FFF2-40B4-BE49-F238E27FC236}">
                              <a16:creationId xmlns:a16="http://schemas.microsoft.com/office/drawing/2014/main" id="{16A2AA72-7028-441E-8205-1F9C3B286C1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1063081" y="4932755"/>
                          <a:ext cx="2173288" cy="21828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78E95AE-64E8-4F06-A36F-E81EEBF97226}"/>
                </a:ext>
              </a:extLst>
            </p:cNvPr>
            <p:cNvSpPr txBox="1"/>
            <p:nvPr/>
          </p:nvSpPr>
          <p:spPr>
            <a:xfrm>
              <a:off x="599607" y="4702820"/>
              <a:ext cx="6912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 actin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AB76580C-8775-4439-9DD7-BFEBB3552BD3}"/>
                </a:ext>
              </a:extLst>
            </p:cNvPr>
            <p:cNvSpPr txBox="1"/>
            <p:nvPr/>
          </p:nvSpPr>
          <p:spPr>
            <a:xfrm>
              <a:off x="683563" y="4475138"/>
              <a:ext cx="6126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ZBP1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729952F-4A6E-4302-88EF-C64D3175A585}"/>
                </a:ext>
              </a:extLst>
            </p:cNvPr>
            <p:cNvSpPr txBox="1"/>
            <p:nvPr/>
          </p:nvSpPr>
          <p:spPr>
            <a:xfrm rot="16200000">
              <a:off x="462549" y="5586009"/>
              <a:ext cx="96532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ZBP1/</a:t>
              </a:r>
              <a:r>
                <a:rPr lang="el-GR" sz="105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</p:grpSp>
      <p:sp>
        <p:nvSpPr>
          <p:cNvPr id="25" name="TextBox 24">
            <a:extLst>
              <a:ext uri="{FF2B5EF4-FFF2-40B4-BE49-F238E27FC236}">
                <a16:creationId xmlns:a16="http://schemas.microsoft.com/office/drawing/2014/main" id="{80D785FC-EC44-48B8-B815-0232CE8C8D8F}"/>
              </a:ext>
            </a:extLst>
          </p:cNvPr>
          <p:cNvSpPr txBox="1"/>
          <p:nvPr/>
        </p:nvSpPr>
        <p:spPr>
          <a:xfrm>
            <a:off x="1383250" y="992578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L1 cells</a:t>
            </a:r>
          </a:p>
        </p:txBody>
      </p:sp>
    </p:spTree>
    <p:extLst>
      <p:ext uri="{BB962C8B-B14F-4D97-AF65-F5344CB8AC3E}">
        <p14:creationId xmlns:p14="http://schemas.microsoft.com/office/powerpoint/2010/main" val="135527223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5B6B2CE-320D-4982-B716-8587A6C7D291}"/>
              </a:ext>
            </a:extLst>
          </p:cNvPr>
          <p:cNvSpPr txBox="1"/>
          <p:nvPr/>
        </p:nvSpPr>
        <p:spPr>
          <a:xfrm>
            <a:off x="241248" y="284241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8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4F09CE7-1C78-4110-90E1-8020EBF6073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68239" y="3001975"/>
            <a:ext cx="6392298" cy="284244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003AFA9-2996-4E98-ACC2-CA188BEA6C1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68239" y="284241"/>
            <a:ext cx="7898401" cy="257030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08F3F686-85EE-48BE-9F11-A4145EDAE002}"/>
              </a:ext>
            </a:extLst>
          </p:cNvPr>
          <p:cNvSpPr/>
          <p:nvPr/>
        </p:nvSpPr>
        <p:spPr>
          <a:xfrm>
            <a:off x="2292634" y="284241"/>
            <a:ext cx="28725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C2B1F2AE-E278-4C7B-B0D1-634719F840B1}"/>
              </a:ext>
            </a:extLst>
          </p:cNvPr>
          <p:cNvSpPr/>
          <p:nvPr/>
        </p:nvSpPr>
        <p:spPr>
          <a:xfrm>
            <a:off x="2357926" y="3001975"/>
            <a:ext cx="28725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67933629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8469154-D5CD-4B5C-B203-4EA866D42975}"/>
              </a:ext>
            </a:extLst>
          </p:cNvPr>
          <p:cNvSpPr txBox="1"/>
          <p:nvPr/>
        </p:nvSpPr>
        <p:spPr>
          <a:xfrm>
            <a:off x="241248" y="284241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9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BC039B98-70D9-4069-A635-B9C87F0344D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28029" y="1716600"/>
            <a:ext cx="7924587" cy="31928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08222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835</TotalTime>
  <Words>974</Words>
  <Application>Microsoft Office PowerPoint</Application>
  <PresentationFormat>Widescreen</PresentationFormat>
  <Paragraphs>116</Paragraphs>
  <Slides>9</Slides>
  <Notes>9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9</vt:i4>
      </vt:variant>
    </vt:vector>
  </HeadingPairs>
  <TitlesOfParts>
    <vt:vector size="16" baseType="lpstr">
      <vt:lpstr>Arial</vt:lpstr>
      <vt:lpstr>Calibri</vt:lpstr>
      <vt:lpstr>Calibri Light</vt:lpstr>
      <vt:lpstr>Times New Roman</vt:lpstr>
      <vt:lpstr>Office Theme</vt:lpstr>
      <vt:lpstr>Prism 9</vt:lpstr>
      <vt:lpstr>GraphPad Prism 9 Projec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dav, Santosh K</dc:creator>
  <cp:lastModifiedBy>Mishra, Paras Kumar</cp:lastModifiedBy>
  <cp:revision>813</cp:revision>
  <cp:lastPrinted>2022-11-30T18:41:28Z</cp:lastPrinted>
  <dcterms:created xsi:type="dcterms:W3CDTF">2018-07-19T23:54:10Z</dcterms:created>
  <dcterms:modified xsi:type="dcterms:W3CDTF">2023-03-08T20:21:44Z</dcterms:modified>
</cp:coreProperties>
</file>